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F4B9F5-9AC7-234A-B98E-187730E99FAF}" v="22" dt="2026-01-21T17:11:37.5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336"/>
    <p:restoredTop sz="94640"/>
  </p:normalViewPr>
  <p:slideViewPr>
    <p:cSldViewPr showGuides="1">
      <p:cViewPr varScale="1">
        <p:scale>
          <a:sx n="75" d="100"/>
          <a:sy n="75" d="100"/>
        </p:scale>
        <p:origin x="192" y="1064"/>
      </p:cViewPr>
      <p:guideLst>
        <p:guide orient="horz" pos="2160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el Torres Cebrián" userId="edd93d03-0a2d-4f71-97c0-19bfc5a4ef59" providerId="ADAL" clId="{8F1BF366-95EA-5ABE-8590-CAFEFDB482F7}"/>
    <pc:docChg chg="undo custSel addSld modSld">
      <pc:chgData name="Abel Torres Cebrián" userId="edd93d03-0a2d-4f71-97c0-19bfc5a4ef59" providerId="ADAL" clId="{8F1BF366-95EA-5ABE-8590-CAFEFDB482F7}" dt="2026-01-21T17:11:37.557" v="410"/>
      <pc:docMkLst>
        <pc:docMk/>
      </pc:docMkLst>
      <pc:sldChg chg="addSp delSp modSp add mod">
        <pc:chgData name="Abel Torres Cebrián" userId="edd93d03-0a2d-4f71-97c0-19bfc5a4ef59" providerId="ADAL" clId="{8F1BF366-95EA-5ABE-8590-CAFEFDB482F7}" dt="2026-01-21T17:04:38.684" v="166"/>
        <pc:sldMkLst>
          <pc:docMk/>
          <pc:sldMk cId="3127291750" sldId="260"/>
        </pc:sldMkLst>
        <pc:spChg chg="or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2" creationId="{20AA3502-B6C0-7C2D-11B1-44D9C8448D92}"/>
          </ac:spMkLst>
        </pc:spChg>
        <pc:spChg chg="mo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4" creationId="{66EF2C98-1556-6DE5-90AE-9FC18F67AD1C}"/>
          </ac:spMkLst>
        </pc:spChg>
        <pc:spChg chg="mod ord">
          <ac:chgData name="Abel Torres Cebrián" userId="edd93d03-0a2d-4f71-97c0-19bfc5a4ef59" providerId="ADAL" clId="{8F1BF366-95EA-5ABE-8590-CAFEFDB482F7}" dt="2026-01-21T17:03:25.282" v="131" actId="27636"/>
          <ac:spMkLst>
            <pc:docMk/>
            <pc:sldMk cId="3127291750" sldId="260"/>
            <ac:spMk id="7" creationId="{C5A49EE6-B94C-FDA8-DDA0-3377B4636BD5}"/>
          </ac:spMkLst>
        </pc:spChg>
        <pc:spChg chg="add mod">
          <ac:chgData name="Abel Torres Cebrián" userId="edd93d03-0a2d-4f71-97c0-19bfc5a4ef59" providerId="ADAL" clId="{8F1BF366-95EA-5ABE-8590-CAFEFDB482F7}" dt="2026-01-21T17:04:34.506" v="165" actId="1035"/>
          <ac:spMkLst>
            <pc:docMk/>
            <pc:sldMk cId="3127291750" sldId="260"/>
            <ac:spMk id="10" creationId="{B7ADEB0B-C7B5-4E3A-48BA-A9A00CE3B654}"/>
          </ac:spMkLst>
        </pc:spChg>
        <pc:spChg chg="add mod">
          <ac:chgData name="Abel Torres Cebrián" userId="edd93d03-0a2d-4f71-97c0-19bfc5a4ef59" providerId="ADAL" clId="{8F1BF366-95EA-5ABE-8590-CAFEFDB482F7}" dt="2026-01-21T17:03:10.023" v="125"/>
          <ac:spMkLst>
            <pc:docMk/>
            <pc:sldMk cId="3127291750" sldId="260"/>
            <ac:spMk id="11" creationId="{53415A63-AAE3-4108-C3C0-C36D1AECD7DE}"/>
          </ac:spMkLst>
        </pc:spChg>
        <pc:spChg chg="add mod">
          <ac:chgData name="Abel Torres Cebrián" userId="edd93d03-0a2d-4f71-97c0-19bfc5a4ef59" providerId="ADAL" clId="{8F1BF366-95EA-5ABE-8590-CAFEFDB482F7}" dt="2026-01-21T17:04:38.684" v="166"/>
          <ac:spMkLst>
            <pc:docMk/>
            <pc:sldMk cId="3127291750" sldId="260"/>
            <ac:spMk id="12" creationId="{1A05ADF7-FBAD-3CEF-B1F9-43BA485FBEA0}"/>
          </ac:spMkLst>
        </pc:spChg>
        <pc:spChg chg="add del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43" creationId="{8781E745-66CB-991A-7060-133603596724}"/>
          </ac:spMkLst>
        </pc:spChg>
        <pc:spChg chg="add del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45" creationId="{D7C488E0-86CF-7D0C-52A7-B8E6B9BBA498}"/>
          </ac:spMkLst>
        </pc:spChg>
        <pc:spChg chg="add del">
          <ac:chgData name="Abel Torres Cebrián" userId="edd93d03-0a2d-4f71-97c0-19bfc5a4ef59" providerId="ADAL" clId="{8F1BF366-95EA-5ABE-8590-CAFEFDB482F7}" dt="2026-01-21T17:00:43.879" v="58" actId="26606"/>
          <ac:spMkLst>
            <pc:docMk/>
            <pc:sldMk cId="3127291750" sldId="260"/>
            <ac:spMk id="47" creationId="{B712E947-0734-45F9-9C4F-41114EC3A33E}"/>
          </ac:spMkLst>
        </pc:spChg>
        <pc:spChg chg="add del">
          <ac:chgData name="Abel Torres Cebrián" userId="edd93d03-0a2d-4f71-97c0-19bfc5a4ef59" providerId="ADAL" clId="{8F1BF366-95EA-5ABE-8590-CAFEFDB482F7}" dt="2026-01-21T17:00:43.879" v="58" actId="26606"/>
          <ac:spMkLst>
            <pc:docMk/>
            <pc:sldMk cId="3127291750" sldId="260"/>
            <ac:spMk id="48" creationId="{5A65989E-BBD5-44D7-AA86-7AFD5D46BBC0}"/>
          </ac:spMkLst>
        </pc:spChg>
        <pc:spChg chg="add del">
          <ac:chgData name="Abel Torres Cebrián" userId="edd93d03-0a2d-4f71-97c0-19bfc5a4ef59" providerId="ADAL" clId="{8F1BF366-95EA-5ABE-8590-CAFEFDB482F7}" dt="2026-01-21T17:00:31.985" v="56" actId="26606"/>
          <ac:spMkLst>
            <pc:docMk/>
            <pc:sldMk cId="3127291750" sldId="260"/>
            <ac:spMk id="50" creationId="{69D47016-023F-44BD-981C-50E7A10A6609}"/>
          </ac:spMkLst>
        </pc:spChg>
        <pc:spChg chg="add del">
          <ac:chgData name="Abel Torres Cebrián" userId="edd93d03-0a2d-4f71-97c0-19bfc5a4ef59" providerId="ADAL" clId="{8F1BF366-95EA-5ABE-8590-CAFEFDB482F7}" dt="2026-01-21T17:00:31.985" v="56" actId="26606"/>
          <ac:spMkLst>
            <pc:docMk/>
            <pc:sldMk cId="3127291750" sldId="260"/>
            <ac:spMk id="52" creationId="{6D8B37B0-0682-433E-BC8D-498C04ABD9A7}"/>
          </ac:spMkLst>
        </pc:spChg>
        <pc:spChg chg="add del">
          <ac:chgData name="Abel Torres Cebrián" userId="edd93d03-0a2d-4f71-97c0-19bfc5a4ef59" providerId="ADAL" clId="{8F1BF366-95EA-5ABE-8590-CAFEFDB482F7}" dt="2026-01-21T17:00:43.879" v="58" actId="26606"/>
          <ac:spMkLst>
            <pc:docMk/>
            <pc:sldMk cId="3127291750" sldId="260"/>
            <ac:spMk id="54" creationId="{231A2881-D8D7-4A7D-ACA3-E9F849F853D8}"/>
          </ac:spMkLst>
        </pc:spChg>
        <pc:spChg chg="add del">
          <ac:chgData name="Abel Torres Cebrián" userId="edd93d03-0a2d-4f71-97c0-19bfc5a4ef59" providerId="ADAL" clId="{8F1BF366-95EA-5ABE-8590-CAFEFDB482F7}" dt="2026-01-21T17:00:44.404" v="60" actId="26606"/>
          <ac:spMkLst>
            <pc:docMk/>
            <pc:sldMk cId="3127291750" sldId="260"/>
            <ac:spMk id="56" creationId="{0DA909B4-15FF-46A6-8A7F-7AEF977FE9ED}"/>
          </ac:spMkLst>
        </pc:spChg>
        <pc:spChg chg="add del">
          <ac:chgData name="Abel Torres Cebrián" userId="edd93d03-0a2d-4f71-97c0-19bfc5a4ef59" providerId="ADAL" clId="{8F1BF366-95EA-5ABE-8590-CAFEFDB482F7}" dt="2026-01-21T17:00:44.404" v="60" actId="26606"/>
          <ac:spMkLst>
            <pc:docMk/>
            <pc:sldMk cId="3127291750" sldId="260"/>
            <ac:spMk id="57" creationId="{149FB5C3-7336-4FE0-A30C-CC0A3646D499}"/>
          </ac:spMkLst>
        </pc:spChg>
        <pc:spChg chg="add del">
          <ac:chgData name="Abel Torres Cebrián" userId="edd93d03-0a2d-4f71-97c0-19bfc5a4ef59" providerId="ADAL" clId="{8F1BF366-95EA-5ABE-8590-CAFEFDB482F7}" dt="2026-01-21T17:00:44.404" v="60" actId="26606"/>
          <ac:spMkLst>
            <pc:docMk/>
            <pc:sldMk cId="3127291750" sldId="260"/>
            <ac:spMk id="58" creationId="{1382A32C-5B0C-4B1C-A074-76C6DBCC9F87}"/>
          </ac:spMkLst>
        </pc:spChg>
        <pc:spChg chg="add del">
          <ac:chgData name="Abel Torres Cebrián" userId="edd93d03-0a2d-4f71-97c0-19bfc5a4ef59" providerId="ADAL" clId="{8F1BF366-95EA-5ABE-8590-CAFEFDB482F7}" dt="2026-01-21T17:00:45.919" v="62" actId="26606"/>
          <ac:spMkLst>
            <pc:docMk/>
            <pc:sldMk cId="3127291750" sldId="260"/>
            <ac:spMk id="62" creationId="{04695F26-39DB-450E-B464-9C76CD233B36}"/>
          </ac:spMkLst>
        </pc:spChg>
        <pc:spChg chg="add del">
          <ac:chgData name="Abel Torres Cebrián" userId="edd93d03-0a2d-4f71-97c0-19bfc5a4ef59" providerId="ADAL" clId="{8F1BF366-95EA-5ABE-8590-CAFEFDB482F7}" dt="2026-01-21T17:00:45.919" v="62" actId="26606"/>
          <ac:spMkLst>
            <pc:docMk/>
            <pc:sldMk cId="3127291750" sldId="260"/>
            <ac:spMk id="63" creationId="{2F42E55F-A297-474F-AF2D-6D3A15822BCA}"/>
          </ac:spMkLst>
        </pc:spChg>
        <pc:spChg chg="add del">
          <ac:chgData name="Abel Torres Cebrián" userId="edd93d03-0a2d-4f71-97c0-19bfc5a4ef59" providerId="ADAL" clId="{8F1BF366-95EA-5ABE-8590-CAFEFDB482F7}" dt="2026-01-21T17:00:48.164" v="64" actId="26606"/>
          <ac:spMkLst>
            <pc:docMk/>
            <pc:sldMk cId="3127291750" sldId="260"/>
            <ac:spMk id="69" creationId="{8761DDFE-071F-4200-B0AA-394476C2D2D6}"/>
          </ac:spMkLst>
        </pc:spChg>
        <pc:spChg chg="add del">
          <ac:chgData name="Abel Torres Cebrián" userId="edd93d03-0a2d-4f71-97c0-19bfc5a4ef59" providerId="ADAL" clId="{8F1BF366-95EA-5ABE-8590-CAFEFDB482F7}" dt="2026-01-21T17:01:02.307" v="66" actId="26606"/>
          <ac:spMkLst>
            <pc:docMk/>
            <pc:sldMk cId="3127291750" sldId="260"/>
            <ac:spMk id="71" creationId="{5AC1364A-3E3D-4F0D-8776-78AF3A270DD6}"/>
          </ac:spMkLst>
        </pc:spChg>
        <pc:spChg chg="add del">
          <ac:chgData name="Abel Torres Cebrián" userId="edd93d03-0a2d-4f71-97c0-19bfc5a4ef59" providerId="ADAL" clId="{8F1BF366-95EA-5ABE-8590-CAFEFDB482F7}" dt="2026-01-21T17:01:02.307" v="66" actId="26606"/>
          <ac:spMkLst>
            <pc:docMk/>
            <pc:sldMk cId="3127291750" sldId="260"/>
            <ac:spMk id="72" creationId="{3FCFB1DE-0B7E-48CC-BA90-B2AB0889F9D6}"/>
          </ac:spMkLst>
        </pc:spChg>
        <pc:spChg chg="ad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74" creationId="{8F7AFB9A-7364-478C-B48B-8523CDD9AE8D}"/>
          </ac:spMkLst>
        </pc:spChg>
        <pc:spChg chg="ad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75" creationId="{36678033-86B6-40E6-BE90-78D8ED4E3A31}"/>
          </ac:spMkLst>
        </pc:spChg>
        <pc:spChg chg="ad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76" creationId="{D2542E1A-076E-4A34-BB67-2BF961754E0C}"/>
          </ac:spMkLst>
        </pc:spChg>
        <pc:spChg chg="ad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77" creationId="{75C56826-D4E5-42ED-8529-079651CB3005}"/>
          </ac:spMkLst>
        </pc:spChg>
        <pc:spChg chg="add">
          <ac:chgData name="Abel Torres Cebrián" userId="edd93d03-0a2d-4f71-97c0-19bfc5a4ef59" providerId="ADAL" clId="{8F1BF366-95EA-5ABE-8590-CAFEFDB482F7}" dt="2026-01-21T17:01:02.314" v="67" actId="26606"/>
          <ac:spMkLst>
            <pc:docMk/>
            <pc:sldMk cId="3127291750" sldId="260"/>
            <ac:spMk id="78" creationId="{82095FCE-EF05-4443-B97A-85DEE3A5CA17}"/>
          </ac:spMkLst>
        </pc:spChg>
        <pc:grpChg chg="add del">
          <ac:chgData name="Abel Torres Cebrián" userId="edd93d03-0a2d-4f71-97c0-19bfc5a4ef59" providerId="ADAL" clId="{8F1BF366-95EA-5ABE-8590-CAFEFDB482F7}" dt="2026-01-21T17:00:45.919" v="62" actId="26606"/>
          <ac:grpSpMkLst>
            <pc:docMk/>
            <pc:sldMk cId="3127291750" sldId="260"/>
            <ac:grpSpMk id="64" creationId="{972070F7-E065-4D60-8938-9FB8CDB8ACB0}"/>
          </ac:grpSpMkLst>
        </pc:grpChg>
        <pc:picChg chg="add mod ord">
          <ac:chgData name="Abel Torres Cebrián" userId="edd93d03-0a2d-4f71-97c0-19bfc5a4ef59" providerId="ADAL" clId="{8F1BF366-95EA-5ABE-8590-CAFEFDB482F7}" dt="2026-01-21T17:03:38.606" v="134" actId="14100"/>
          <ac:picMkLst>
            <pc:docMk/>
            <pc:sldMk cId="3127291750" sldId="260"/>
            <ac:picMk id="3" creationId="{83305F24-FF3E-C908-3AEC-8F2BAB3C085A}"/>
          </ac:picMkLst>
        </pc:picChg>
        <pc:picChg chg="add mod">
          <ac:chgData name="Abel Torres Cebrián" userId="edd93d03-0a2d-4f71-97c0-19bfc5a4ef59" providerId="ADAL" clId="{8F1BF366-95EA-5ABE-8590-CAFEFDB482F7}" dt="2026-01-21T17:03:35.724" v="133" actId="14100"/>
          <ac:picMkLst>
            <pc:docMk/>
            <pc:sldMk cId="3127291750" sldId="260"/>
            <ac:picMk id="5" creationId="{E5A50703-0C08-6F38-8BAB-F38FA0E95ECF}"/>
          </ac:picMkLst>
        </pc:picChg>
        <pc:picChg chg="del">
          <ac:chgData name="Abel Torres Cebrián" userId="edd93d03-0a2d-4f71-97c0-19bfc5a4ef59" providerId="ADAL" clId="{8F1BF366-95EA-5ABE-8590-CAFEFDB482F7}" dt="2026-01-21T16:58:01.751" v="46" actId="478"/>
          <ac:picMkLst>
            <pc:docMk/>
            <pc:sldMk cId="3127291750" sldId="260"/>
            <ac:picMk id="6" creationId="{40903636-7A31-8FB5-9559-E39846EA81D7}"/>
          </ac:picMkLst>
        </pc:picChg>
        <pc:picChg chg="add del mod">
          <ac:chgData name="Abel Torres Cebrián" userId="edd93d03-0a2d-4f71-97c0-19bfc5a4ef59" providerId="ADAL" clId="{8F1BF366-95EA-5ABE-8590-CAFEFDB482F7}" dt="2026-01-21T17:02:35.540" v="74" actId="478"/>
          <ac:picMkLst>
            <pc:docMk/>
            <pc:sldMk cId="3127291750" sldId="260"/>
            <ac:picMk id="8" creationId="{F37C090B-84EA-82A0-9584-14327C6FC42F}"/>
          </ac:picMkLst>
        </pc:picChg>
      </pc:sldChg>
      <pc:sldChg chg="addSp delSp modSp add mod setBg delDesignElem">
        <pc:chgData name="Abel Torres Cebrián" userId="edd93d03-0a2d-4f71-97c0-19bfc5a4ef59" providerId="ADAL" clId="{8F1BF366-95EA-5ABE-8590-CAFEFDB482F7}" dt="2026-01-21T17:07:51.462" v="260" actId="14100"/>
        <pc:sldMkLst>
          <pc:docMk/>
          <pc:sldMk cId="1710594176" sldId="261"/>
        </pc:sldMkLst>
        <pc:spChg chg="mod">
          <ac:chgData name="Abel Torres Cebrián" userId="edd93d03-0a2d-4f71-97c0-19bfc5a4ef59" providerId="ADAL" clId="{8F1BF366-95EA-5ABE-8590-CAFEFDB482F7}" dt="2026-01-21T17:06:11.597" v="188" actId="1035"/>
          <ac:spMkLst>
            <pc:docMk/>
            <pc:sldMk cId="1710594176" sldId="261"/>
            <ac:spMk id="2" creationId="{6841B5A5-E12D-93E2-3282-16673C0415FE}"/>
          </ac:spMkLst>
        </pc:spChg>
        <pc:spChg chg="mod">
          <ac:chgData name="Abel Torres Cebrián" userId="edd93d03-0a2d-4f71-97c0-19bfc5a4ef59" providerId="ADAL" clId="{8F1BF366-95EA-5ABE-8590-CAFEFDB482F7}" dt="2026-01-21T17:05:22.170" v="173" actId="27636"/>
          <ac:spMkLst>
            <pc:docMk/>
            <pc:sldMk cId="1710594176" sldId="261"/>
            <ac:spMk id="7" creationId="{9136BBE7-DA87-D804-CF13-3A2F1D526846}"/>
          </ac:spMkLst>
        </pc:spChg>
        <pc:spChg chg="add mod">
          <ac:chgData name="Abel Torres Cebrián" userId="edd93d03-0a2d-4f71-97c0-19bfc5a4ef59" providerId="ADAL" clId="{8F1BF366-95EA-5ABE-8590-CAFEFDB482F7}" dt="2026-01-21T17:07:18.472" v="252"/>
          <ac:spMkLst>
            <pc:docMk/>
            <pc:sldMk cId="1710594176" sldId="261"/>
            <ac:spMk id="8" creationId="{9E1CBA76-67D1-68BC-4542-6FB55A2A7CE6}"/>
          </ac:spMkLst>
        </pc:spChg>
        <pc:spChg chg="del mod">
          <ac:chgData name="Abel Torres Cebrián" userId="edd93d03-0a2d-4f71-97c0-19bfc5a4ef59" providerId="ADAL" clId="{8F1BF366-95EA-5ABE-8590-CAFEFDB482F7}" dt="2026-01-21T17:07:07.609" v="211" actId="478"/>
          <ac:spMkLst>
            <pc:docMk/>
            <pc:sldMk cId="1710594176" sldId="261"/>
            <ac:spMk id="10" creationId="{4EF6679A-0004-9020-4A35-C4BDB161A5E7}"/>
          </ac:spMkLst>
        </pc:spChg>
        <pc:spChg chg="mod">
          <ac:chgData name="Abel Torres Cebrián" userId="edd93d03-0a2d-4f71-97c0-19bfc5a4ef59" providerId="ADAL" clId="{8F1BF366-95EA-5ABE-8590-CAFEFDB482F7}" dt="2026-01-21T17:07:31.224" v="257" actId="20577"/>
          <ac:spMkLst>
            <pc:docMk/>
            <pc:sldMk cId="1710594176" sldId="261"/>
            <ac:spMk id="11" creationId="{22FB12A1-9679-44E9-E0FF-0FD056C3EF1E}"/>
          </ac:spMkLst>
        </pc:spChg>
        <pc:spChg chg="del">
          <ac:chgData name="Abel Torres Cebrián" userId="edd93d03-0a2d-4f71-97c0-19bfc5a4ef59" providerId="ADAL" clId="{8F1BF366-95EA-5ABE-8590-CAFEFDB482F7}" dt="2026-01-21T17:04:43.512" v="168"/>
          <ac:spMkLst>
            <pc:docMk/>
            <pc:sldMk cId="1710594176" sldId="261"/>
            <ac:spMk id="74" creationId="{8BF5222E-49BC-4A64-E35D-BBBA01E6F007}"/>
          </ac:spMkLst>
        </pc:spChg>
        <pc:spChg chg="del">
          <ac:chgData name="Abel Torres Cebrián" userId="edd93d03-0a2d-4f71-97c0-19bfc5a4ef59" providerId="ADAL" clId="{8F1BF366-95EA-5ABE-8590-CAFEFDB482F7}" dt="2026-01-21T17:04:43.512" v="168"/>
          <ac:spMkLst>
            <pc:docMk/>
            <pc:sldMk cId="1710594176" sldId="261"/>
            <ac:spMk id="75" creationId="{E078FB56-1776-85BC-A795-182DEC1A240B}"/>
          </ac:spMkLst>
        </pc:spChg>
        <pc:spChg chg="del">
          <ac:chgData name="Abel Torres Cebrián" userId="edd93d03-0a2d-4f71-97c0-19bfc5a4ef59" providerId="ADAL" clId="{8F1BF366-95EA-5ABE-8590-CAFEFDB482F7}" dt="2026-01-21T17:04:43.512" v="168"/>
          <ac:spMkLst>
            <pc:docMk/>
            <pc:sldMk cId="1710594176" sldId="261"/>
            <ac:spMk id="76" creationId="{55C10303-6405-13BB-8523-FE463C1DCAF1}"/>
          </ac:spMkLst>
        </pc:spChg>
        <pc:spChg chg="del">
          <ac:chgData name="Abel Torres Cebrián" userId="edd93d03-0a2d-4f71-97c0-19bfc5a4ef59" providerId="ADAL" clId="{8F1BF366-95EA-5ABE-8590-CAFEFDB482F7}" dt="2026-01-21T17:04:43.512" v="168"/>
          <ac:spMkLst>
            <pc:docMk/>
            <pc:sldMk cId="1710594176" sldId="261"/>
            <ac:spMk id="77" creationId="{619E0B03-676C-878D-28EE-7B4B131CD1C8}"/>
          </ac:spMkLst>
        </pc:spChg>
        <pc:spChg chg="del">
          <ac:chgData name="Abel Torres Cebrián" userId="edd93d03-0a2d-4f71-97c0-19bfc5a4ef59" providerId="ADAL" clId="{8F1BF366-95EA-5ABE-8590-CAFEFDB482F7}" dt="2026-01-21T17:04:43.512" v="168"/>
          <ac:spMkLst>
            <pc:docMk/>
            <pc:sldMk cId="1710594176" sldId="261"/>
            <ac:spMk id="78" creationId="{215BB624-7B2B-33C4-923F-DA9FA79349AE}"/>
          </ac:spMkLst>
        </pc:spChg>
        <pc:picChg chg="del">
          <ac:chgData name="Abel Torres Cebrián" userId="edd93d03-0a2d-4f71-97c0-19bfc5a4ef59" providerId="ADAL" clId="{8F1BF366-95EA-5ABE-8590-CAFEFDB482F7}" dt="2026-01-21T17:05:56.915" v="174" actId="478"/>
          <ac:picMkLst>
            <pc:docMk/>
            <pc:sldMk cId="1710594176" sldId="261"/>
            <ac:picMk id="3" creationId="{38EB4430-EBAA-AAC4-7874-94559642F6A1}"/>
          </ac:picMkLst>
        </pc:picChg>
        <pc:picChg chg="del mod">
          <ac:chgData name="Abel Torres Cebrián" userId="edd93d03-0a2d-4f71-97c0-19bfc5a4ef59" providerId="ADAL" clId="{8F1BF366-95EA-5ABE-8590-CAFEFDB482F7}" dt="2026-01-21T17:06:06.373" v="179" actId="478"/>
          <ac:picMkLst>
            <pc:docMk/>
            <pc:sldMk cId="1710594176" sldId="261"/>
            <ac:picMk id="5" creationId="{B1E0515A-6F3F-272F-1A4F-CE420F2B95A8}"/>
          </ac:picMkLst>
        </pc:picChg>
        <pc:picChg chg="add mod">
          <ac:chgData name="Abel Torres Cebrián" userId="edd93d03-0a2d-4f71-97c0-19bfc5a4ef59" providerId="ADAL" clId="{8F1BF366-95EA-5ABE-8590-CAFEFDB482F7}" dt="2026-01-21T17:06:03.350" v="177" actId="14100"/>
          <ac:picMkLst>
            <pc:docMk/>
            <pc:sldMk cId="1710594176" sldId="261"/>
            <ac:picMk id="6" creationId="{6666E769-569E-A850-0DEB-2C065A1F91F7}"/>
          </ac:picMkLst>
        </pc:picChg>
        <pc:picChg chg="add mod">
          <ac:chgData name="Abel Torres Cebrián" userId="edd93d03-0a2d-4f71-97c0-19bfc5a4ef59" providerId="ADAL" clId="{8F1BF366-95EA-5ABE-8590-CAFEFDB482F7}" dt="2026-01-21T17:07:51.462" v="260" actId="14100"/>
          <ac:picMkLst>
            <pc:docMk/>
            <pc:sldMk cId="1710594176" sldId="261"/>
            <ac:picMk id="9" creationId="{36DDF3E9-551C-6285-D24F-4734BEC9F31C}"/>
          </ac:picMkLst>
        </pc:picChg>
      </pc:sldChg>
      <pc:sldChg chg="addSp delSp modSp add mod">
        <pc:chgData name="Abel Torres Cebrián" userId="edd93d03-0a2d-4f71-97c0-19bfc5a4ef59" providerId="ADAL" clId="{8F1BF366-95EA-5ABE-8590-CAFEFDB482F7}" dt="2026-01-21T17:11:37.557" v="410"/>
        <pc:sldMkLst>
          <pc:docMk/>
          <pc:sldMk cId="1465144182" sldId="262"/>
        </pc:sldMkLst>
        <pc:spChg chg="mod">
          <ac:chgData name="Abel Torres Cebrián" userId="edd93d03-0a2d-4f71-97c0-19bfc5a4ef59" providerId="ADAL" clId="{8F1BF366-95EA-5ABE-8590-CAFEFDB482F7}" dt="2026-01-21T17:08:26.179" v="266" actId="27636"/>
          <ac:spMkLst>
            <pc:docMk/>
            <pc:sldMk cId="1465144182" sldId="262"/>
            <ac:spMk id="7" creationId="{D8A0038C-1EAF-DF66-F5B5-C30A446DCDA2}"/>
          </ac:spMkLst>
        </pc:spChg>
        <pc:spChg chg="mod">
          <ac:chgData name="Abel Torres Cebrián" userId="edd93d03-0a2d-4f71-97c0-19bfc5a4ef59" providerId="ADAL" clId="{8F1BF366-95EA-5ABE-8590-CAFEFDB482F7}" dt="2026-01-21T17:10:21.743" v="335" actId="20577"/>
          <ac:spMkLst>
            <pc:docMk/>
            <pc:sldMk cId="1465144182" sldId="262"/>
            <ac:spMk id="8" creationId="{17278B14-F00E-9538-944A-7FC886195495}"/>
          </ac:spMkLst>
        </pc:spChg>
        <pc:spChg chg="mod">
          <ac:chgData name="Abel Torres Cebrián" userId="edd93d03-0a2d-4f71-97c0-19bfc5a4ef59" providerId="ADAL" clId="{8F1BF366-95EA-5ABE-8590-CAFEFDB482F7}" dt="2026-01-21T17:10:10.855" v="332" actId="20577"/>
          <ac:spMkLst>
            <pc:docMk/>
            <pc:sldMk cId="1465144182" sldId="262"/>
            <ac:spMk id="11" creationId="{95406994-C6FE-CF33-066D-FD85A52C07E9}"/>
          </ac:spMkLst>
        </pc:spChg>
        <pc:spChg chg="add mod">
          <ac:chgData name="Abel Torres Cebrián" userId="edd93d03-0a2d-4f71-97c0-19bfc5a4ef59" providerId="ADAL" clId="{8F1BF366-95EA-5ABE-8590-CAFEFDB482F7}" dt="2026-01-21T17:11:36.945" v="409" actId="1036"/>
          <ac:spMkLst>
            <pc:docMk/>
            <pc:sldMk cId="1465144182" sldId="262"/>
            <ac:spMk id="13" creationId="{51CA1688-74CC-099A-A800-67DDBEE5F632}"/>
          </ac:spMkLst>
        </pc:spChg>
        <pc:spChg chg="add mod">
          <ac:chgData name="Abel Torres Cebrián" userId="edd93d03-0a2d-4f71-97c0-19bfc5a4ef59" providerId="ADAL" clId="{8F1BF366-95EA-5ABE-8590-CAFEFDB482F7}" dt="2026-01-21T17:11:37.557" v="410"/>
          <ac:spMkLst>
            <pc:docMk/>
            <pc:sldMk cId="1465144182" sldId="262"/>
            <ac:spMk id="14" creationId="{45F8006B-0086-A479-7032-1556FFDCB6FE}"/>
          </ac:spMkLst>
        </pc:spChg>
        <pc:picChg chg="add mod">
          <ac:chgData name="Abel Torres Cebrián" userId="edd93d03-0a2d-4f71-97c0-19bfc5a4ef59" providerId="ADAL" clId="{8F1BF366-95EA-5ABE-8590-CAFEFDB482F7}" dt="2026-01-21T17:10:37.608" v="337" actId="1076"/>
          <ac:picMkLst>
            <pc:docMk/>
            <pc:sldMk cId="1465144182" sldId="262"/>
            <ac:picMk id="3" creationId="{88C446BA-7F68-1F76-9B6A-7122388437FB}"/>
          </ac:picMkLst>
        </pc:picChg>
        <pc:picChg chg="add mod">
          <ac:chgData name="Abel Torres Cebrián" userId="edd93d03-0a2d-4f71-97c0-19bfc5a4ef59" providerId="ADAL" clId="{8F1BF366-95EA-5ABE-8590-CAFEFDB482F7}" dt="2026-01-21T17:10:46.817" v="339" actId="1076"/>
          <ac:picMkLst>
            <pc:docMk/>
            <pc:sldMk cId="1465144182" sldId="262"/>
            <ac:picMk id="5" creationId="{5F6A1DDE-92A1-A736-2F14-E34EF38203AE}"/>
          </ac:picMkLst>
        </pc:picChg>
        <pc:picChg chg="del">
          <ac:chgData name="Abel Torres Cebrián" userId="edd93d03-0a2d-4f71-97c0-19bfc5a4ef59" providerId="ADAL" clId="{8F1BF366-95EA-5ABE-8590-CAFEFDB482F7}" dt="2026-01-21T17:10:14.982" v="333" actId="478"/>
          <ac:picMkLst>
            <pc:docMk/>
            <pc:sldMk cId="1465144182" sldId="262"/>
            <ac:picMk id="6" creationId="{3F88A8D7-18C6-BE1A-3AAF-5599561C847D}"/>
          </ac:picMkLst>
        </pc:picChg>
        <pc:picChg chg="del">
          <ac:chgData name="Abel Torres Cebrián" userId="edd93d03-0a2d-4f71-97c0-19bfc5a4ef59" providerId="ADAL" clId="{8F1BF366-95EA-5ABE-8590-CAFEFDB482F7}" dt="2026-01-21T17:10:15.602" v="334" actId="478"/>
          <ac:picMkLst>
            <pc:docMk/>
            <pc:sldMk cId="1465144182" sldId="262"/>
            <ac:picMk id="9" creationId="{89A50E58-4335-4918-7558-BB639F4D1B5C}"/>
          </ac:picMkLst>
        </pc:picChg>
        <pc:picChg chg="add mod">
          <ac:chgData name="Abel Torres Cebrián" userId="edd93d03-0a2d-4f71-97c0-19bfc5a4ef59" providerId="ADAL" clId="{8F1BF366-95EA-5ABE-8590-CAFEFDB482F7}" dt="2026-01-21T17:10:57.590" v="341" actId="1076"/>
          <ac:picMkLst>
            <pc:docMk/>
            <pc:sldMk cId="1465144182" sldId="262"/>
            <ac:picMk id="10" creationId="{C93C4D64-6A75-B5E1-D2C1-295B3C0C70DD}"/>
          </ac:picMkLst>
        </pc:picChg>
        <pc:picChg chg="add mod">
          <ac:chgData name="Abel Torres Cebrián" userId="edd93d03-0a2d-4f71-97c0-19bfc5a4ef59" providerId="ADAL" clId="{8F1BF366-95EA-5ABE-8590-CAFEFDB482F7}" dt="2026-01-21T17:11:06.693" v="343" actId="1076"/>
          <ac:picMkLst>
            <pc:docMk/>
            <pc:sldMk cId="1465144182" sldId="262"/>
            <ac:picMk id="12" creationId="{1AF65065-CEAC-FD05-05E2-AC21A2D9918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B564FE-200A-1E01-6C27-D2729A62BF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DBD58FE-552A-A6AA-8E44-B74DAF3E19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B2D7280-FD82-2A43-3215-6D45FD2A6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5D5CA26-DCD4-0A21-06FA-18A5ED88E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43B794E-A7EA-C958-16F9-ECD625B50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2537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EF0B5D8-20FC-0195-354B-3408EBF0D7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0F0E429-CD73-640A-6814-2B8F82CB12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6002E69-F3E6-B3EF-8176-E7D4662D1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5550749-414B-CF12-4DAA-2F149E292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9BF82A8-E3FF-45D2-4613-D9836B2BA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25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1F98C22-11F6-0CF0-C5AF-D3CD06ABC4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BBE0A2F-EB68-0658-0751-F0285BED7E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89693D6-7597-B39A-0A0E-118764EFA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3410C0C-9EEE-76F0-D99D-09E31DB48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D7226C4-D562-F053-21B9-15EC4CF480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73810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06287B8-9B0F-0FBA-1E84-8654DFAA7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EB54355-86E8-27D7-F6FD-A51B833739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B6BAD4D-8311-92E3-6337-7FE5AB57A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343724-513B-B0FB-3C74-27C92EDA1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66A3B6-2C55-7B19-D627-9E4597C30C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700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4A5C59-219D-DEBB-8114-45D2D8EC8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2C80D41-9DD2-154F-59F9-40EA20E336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AAB2475-3EF1-96A4-9009-A53290471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08351CB-549E-AB13-132D-3091E147E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6555881-0E24-2260-9832-E06F75E35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3177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A455CF-2EE4-E2FC-1143-B5BE229C5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B8B2331-6A87-9D7F-0E25-D3C0145F43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D1915B-7D9C-9F81-7B15-41E80231DB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6BBBED4-1C60-629A-10E4-F096D9E3A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A890FE2-A746-A4B3-C244-8F7DADE70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FC4F42C-58BF-4935-25CA-F7EDC1EBA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800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13D2E7-94EF-D6D5-F3E1-C64D82C85C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760210B-3F12-412D-858F-689CE03438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70284FF-701D-8FFE-987B-95B67BEFD8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2FE2B814-FE98-697E-E1D2-0F1016734E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E931B03-F08A-9D36-E788-CD1C4A8572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EEE5358-9F6A-684E-CF8A-90A8D148E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DCB0BF3-492B-B8AB-AB0F-C2A985C80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D0CBB57-3D41-7D55-B688-9A6712ACA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0882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CA4F195-06CB-A136-E57B-135883B60F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5C08355-0FBD-9B18-73C6-4BA950B97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54ED8CB-D528-F19F-7E43-8FB409308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985DD67-8858-37B0-E97D-2A5159E02A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6002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797DC0F-39CE-AC70-062D-D95450881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D172AB5-A655-B8FF-A61F-360E7E09C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DD018374-F956-030D-31F7-A4EDA812D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25967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E854C5-CC3D-B426-9A86-862652EB5C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69829C1-7743-A9BA-DFB8-13E75861B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5C7D8A4-1F15-57D8-89D4-36C3454818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F43B385-A39C-F608-EBFF-3784A06E8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6D70657-B408-A1C4-A500-8581543B3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088C7720-C1FF-34FE-BCFE-82F23D6BE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4020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031ED0B-8B11-A844-EBE2-5CF5E5355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4E85B3D-8F9B-A047-BA92-D7C0954EF0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7DFF39B-E1F9-6D23-1FB3-942B3231BE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C263B00-2C55-8ECE-F9A0-451948F48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45318A0-7462-EF70-A43A-19352A851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AA84C4C-2513-8992-A765-661114C6B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2697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0244241-B7F0-F422-035D-6A4E74A0D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17B7CAD-1B89-B1A1-EAF7-2219D76C4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B1DB6C3-7A0D-6D11-BEAC-5C5E5F114B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9DFAED-D4E3-AD49-891B-5440F6F97C75}" type="datetimeFigureOut">
              <a:rPr lang="es-ES" smtClean="0"/>
              <a:t>21/1/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8F4A88D-36EB-1365-A972-4C6D1A1724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30E5E77-8B82-DB9A-9249-122ABB920A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36256-C22D-1E40-B609-881734CA311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8857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3" name="Rectangle 12">
            <a:extLst>
              <a:ext uri="{FF2B5EF4-FFF2-40B4-BE49-F238E27FC236}">
                <a16:creationId xmlns:a16="http://schemas.microsoft.com/office/drawing/2014/main" id="{352BEC0E-22F8-46D0-9632-375DB541B0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164E0C50-E0F9-BC70-E115-498CA2E18C93}"/>
              </a:ext>
            </a:extLst>
          </p:cNvPr>
          <p:cNvSpPr txBox="1"/>
          <p:nvPr/>
        </p:nvSpPr>
        <p:spPr>
          <a:xfrm>
            <a:off x="640080" y="329184"/>
            <a:ext cx="6894576" cy="178308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3800" b="1">
                <a:latin typeface="+mj-lt"/>
                <a:ea typeface="+mj-ea"/>
                <a:cs typeface="+mj-cs"/>
              </a:rPr>
              <a:t>Appendix A – Annotation interface and protocol (screenshots)</a:t>
            </a:r>
          </a:p>
        </p:txBody>
      </p:sp>
      <p:sp>
        <p:nvSpPr>
          <p:cNvPr id="15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58952" y="2395728"/>
            <a:ext cx="4243589" cy="18288"/>
          </a:xfrm>
          <a:custGeom>
            <a:avLst/>
            <a:gdLst>
              <a:gd name="csX0" fmla="*/ 0 w 4243589"/>
              <a:gd name="csY0" fmla="*/ 0 h 18288"/>
              <a:gd name="csX1" fmla="*/ 478919 w 4243589"/>
              <a:gd name="csY1" fmla="*/ 0 h 18288"/>
              <a:gd name="csX2" fmla="*/ 957839 w 4243589"/>
              <a:gd name="csY2" fmla="*/ 0 h 18288"/>
              <a:gd name="csX3" fmla="*/ 1521630 w 4243589"/>
              <a:gd name="csY3" fmla="*/ 0 h 18288"/>
              <a:gd name="csX4" fmla="*/ 2212729 w 4243589"/>
              <a:gd name="csY4" fmla="*/ 0 h 18288"/>
              <a:gd name="csX5" fmla="*/ 2734084 w 4243589"/>
              <a:gd name="csY5" fmla="*/ 0 h 18288"/>
              <a:gd name="csX6" fmla="*/ 3255439 w 4243589"/>
              <a:gd name="csY6" fmla="*/ 0 h 18288"/>
              <a:gd name="csX7" fmla="*/ 4243589 w 4243589"/>
              <a:gd name="csY7" fmla="*/ 0 h 18288"/>
              <a:gd name="csX8" fmla="*/ 4243589 w 4243589"/>
              <a:gd name="csY8" fmla="*/ 18288 h 18288"/>
              <a:gd name="csX9" fmla="*/ 3594926 w 4243589"/>
              <a:gd name="csY9" fmla="*/ 18288 h 18288"/>
              <a:gd name="csX10" fmla="*/ 3073571 w 4243589"/>
              <a:gd name="csY10" fmla="*/ 18288 h 18288"/>
              <a:gd name="csX11" fmla="*/ 2552216 w 4243589"/>
              <a:gd name="csY11" fmla="*/ 18288 h 18288"/>
              <a:gd name="csX12" fmla="*/ 1903553 w 4243589"/>
              <a:gd name="csY12" fmla="*/ 18288 h 18288"/>
              <a:gd name="csX13" fmla="*/ 1212454 w 4243589"/>
              <a:gd name="csY13" fmla="*/ 18288 h 18288"/>
              <a:gd name="csX14" fmla="*/ 733535 w 4243589"/>
              <a:gd name="csY14" fmla="*/ 18288 h 18288"/>
              <a:gd name="csX15" fmla="*/ 0 w 4243589"/>
              <a:gd name="csY15" fmla="*/ 18288 h 18288"/>
              <a:gd name="csX16" fmla="*/ 0 w 4243589"/>
              <a:gd name="csY16" fmla="*/ 0 h 18288"/>
            </a:gdLst>
            <a:ahLst/>
            <a:cxnLst>
              <a:cxn ang="0">
                <a:pos x="csX0" y="csY0"/>
              </a:cxn>
              <a:cxn ang="0">
                <a:pos x="csX1" y="csY1"/>
              </a:cxn>
              <a:cxn ang="0">
                <a:pos x="csX2" y="csY2"/>
              </a:cxn>
              <a:cxn ang="0">
                <a:pos x="csX3" y="csY3"/>
              </a:cxn>
              <a:cxn ang="0">
                <a:pos x="csX4" y="csY4"/>
              </a:cxn>
              <a:cxn ang="0">
                <a:pos x="csX5" y="csY5"/>
              </a:cxn>
              <a:cxn ang="0">
                <a:pos x="csX6" y="csY6"/>
              </a:cxn>
              <a:cxn ang="0">
                <a:pos x="csX7" y="csY7"/>
              </a:cxn>
              <a:cxn ang="0">
                <a:pos x="csX8" y="csY8"/>
              </a:cxn>
              <a:cxn ang="0">
                <a:pos x="csX9" y="csY9"/>
              </a:cxn>
              <a:cxn ang="0">
                <a:pos x="csX10" y="csY10"/>
              </a:cxn>
              <a:cxn ang="0">
                <a:pos x="csX11" y="csY11"/>
              </a:cxn>
              <a:cxn ang="0">
                <a:pos x="csX12" y="csY12"/>
              </a:cxn>
              <a:cxn ang="0">
                <a:pos x="csX13" y="csY13"/>
              </a:cxn>
              <a:cxn ang="0">
                <a:pos x="csX14" y="csY14"/>
              </a:cxn>
              <a:cxn ang="0">
                <a:pos x="csX15" y="csY15"/>
              </a:cxn>
              <a:cxn ang="0">
                <a:pos x="csX16" y="csY16"/>
              </a:cxn>
            </a:cxnLst>
            <a:rect l="l" t="t" r="r" b="b"/>
            <a:pathLst>
              <a:path w="4243589" h="18288" fill="none" extrusionOk="0">
                <a:moveTo>
                  <a:pt x="0" y="0"/>
                </a:moveTo>
                <a:cubicBezTo>
                  <a:pt x="213395" y="-21006"/>
                  <a:pt x="307421" y="-18116"/>
                  <a:pt x="478919" y="0"/>
                </a:cubicBezTo>
                <a:cubicBezTo>
                  <a:pt x="650417" y="18116"/>
                  <a:pt x="831092" y="-21237"/>
                  <a:pt x="957839" y="0"/>
                </a:cubicBezTo>
                <a:cubicBezTo>
                  <a:pt x="1084586" y="21237"/>
                  <a:pt x="1301682" y="25124"/>
                  <a:pt x="1521630" y="0"/>
                </a:cubicBezTo>
                <a:cubicBezTo>
                  <a:pt x="1741578" y="-25124"/>
                  <a:pt x="1970269" y="-29139"/>
                  <a:pt x="2212729" y="0"/>
                </a:cubicBezTo>
                <a:cubicBezTo>
                  <a:pt x="2455189" y="29139"/>
                  <a:pt x="2558847" y="-4796"/>
                  <a:pt x="2734084" y="0"/>
                </a:cubicBezTo>
                <a:cubicBezTo>
                  <a:pt x="2909321" y="4796"/>
                  <a:pt x="3097217" y="-13409"/>
                  <a:pt x="3255439" y="0"/>
                </a:cubicBezTo>
                <a:cubicBezTo>
                  <a:pt x="3413662" y="13409"/>
                  <a:pt x="3979999" y="-10121"/>
                  <a:pt x="4243589" y="0"/>
                </a:cubicBezTo>
                <a:cubicBezTo>
                  <a:pt x="4244484" y="8974"/>
                  <a:pt x="4243043" y="9359"/>
                  <a:pt x="4243589" y="18288"/>
                </a:cubicBezTo>
                <a:cubicBezTo>
                  <a:pt x="4058777" y="31246"/>
                  <a:pt x="3910348" y="3158"/>
                  <a:pt x="3594926" y="18288"/>
                </a:cubicBezTo>
                <a:cubicBezTo>
                  <a:pt x="3279504" y="33418"/>
                  <a:pt x="3319955" y="-3977"/>
                  <a:pt x="3073571" y="18288"/>
                </a:cubicBezTo>
                <a:cubicBezTo>
                  <a:pt x="2827187" y="40553"/>
                  <a:pt x="2767387" y="1863"/>
                  <a:pt x="2552216" y="18288"/>
                </a:cubicBezTo>
                <a:cubicBezTo>
                  <a:pt x="2337046" y="34713"/>
                  <a:pt x="2181871" y="19527"/>
                  <a:pt x="1903553" y="18288"/>
                </a:cubicBezTo>
                <a:cubicBezTo>
                  <a:pt x="1625235" y="17049"/>
                  <a:pt x="1557672" y="24174"/>
                  <a:pt x="1212454" y="18288"/>
                </a:cubicBezTo>
                <a:cubicBezTo>
                  <a:pt x="867236" y="12402"/>
                  <a:pt x="874382" y="15627"/>
                  <a:pt x="733535" y="18288"/>
                </a:cubicBezTo>
                <a:cubicBezTo>
                  <a:pt x="592688" y="20949"/>
                  <a:pt x="183477" y="14753"/>
                  <a:pt x="0" y="18288"/>
                </a:cubicBezTo>
                <a:cubicBezTo>
                  <a:pt x="-229" y="14222"/>
                  <a:pt x="509" y="5816"/>
                  <a:pt x="0" y="0"/>
                </a:cubicBezTo>
                <a:close/>
              </a:path>
              <a:path w="4243589" h="18288" stroke="0" extrusionOk="0">
                <a:moveTo>
                  <a:pt x="0" y="0"/>
                </a:moveTo>
                <a:cubicBezTo>
                  <a:pt x="143690" y="16630"/>
                  <a:pt x="266667" y="14847"/>
                  <a:pt x="521355" y="0"/>
                </a:cubicBezTo>
                <a:cubicBezTo>
                  <a:pt x="776043" y="-14847"/>
                  <a:pt x="814491" y="-17363"/>
                  <a:pt x="1000275" y="0"/>
                </a:cubicBezTo>
                <a:cubicBezTo>
                  <a:pt x="1186059" y="17363"/>
                  <a:pt x="1352504" y="-23507"/>
                  <a:pt x="1521630" y="0"/>
                </a:cubicBezTo>
                <a:cubicBezTo>
                  <a:pt x="1690756" y="23507"/>
                  <a:pt x="1889525" y="5871"/>
                  <a:pt x="2127857" y="0"/>
                </a:cubicBezTo>
                <a:cubicBezTo>
                  <a:pt x="2366189" y="-5871"/>
                  <a:pt x="2620628" y="-27997"/>
                  <a:pt x="2776520" y="0"/>
                </a:cubicBezTo>
                <a:cubicBezTo>
                  <a:pt x="2932412" y="27997"/>
                  <a:pt x="3131683" y="-25073"/>
                  <a:pt x="3467618" y="0"/>
                </a:cubicBezTo>
                <a:cubicBezTo>
                  <a:pt x="3803553" y="25073"/>
                  <a:pt x="4017371" y="3071"/>
                  <a:pt x="4243589" y="0"/>
                </a:cubicBezTo>
                <a:cubicBezTo>
                  <a:pt x="4243134" y="6162"/>
                  <a:pt x="4243492" y="11775"/>
                  <a:pt x="4243589" y="18288"/>
                </a:cubicBezTo>
                <a:cubicBezTo>
                  <a:pt x="4017834" y="-5779"/>
                  <a:pt x="3834586" y="13376"/>
                  <a:pt x="3594926" y="18288"/>
                </a:cubicBezTo>
                <a:cubicBezTo>
                  <a:pt x="3355266" y="23200"/>
                  <a:pt x="3204179" y="2869"/>
                  <a:pt x="2903827" y="18288"/>
                </a:cubicBezTo>
                <a:cubicBezTo>
                  <a:pt x="2603475" y="33707"/>
                  <a:pt x="2526187" y="46187"/>
                  <a:pt x="2212729" y="18288"/>
                </a:cubicBezTo>
                <a:cubicBezTo>
                  <a:pt x="1899271" y="-9611"/>
                  <a:pt x="1966289" y="29692"/>
                  <a:pt x="1733809" y="18288"/>
                </a:cubicBezTo>
                <a:cubicBezTo>
                  <a:pt x="1501329" y="6884"/>
                  <a:pt x="1343612" y="12492"/>
                  <a:pt x="1085146" y="18288"/>
                </a:cubicBezTo>
                <a:cubicBezTo>
                  <a:pt x="826680" y="24084"/>
                  <a:pt x="778184" y="35607"/>
                  <a:pt x="521355" y="18288"/>
                </a:cubicBezTo>
                <a:cubicBezTo>
                  <a:pt x="264526" y="969"/>
                  <a:pt x="120277" y="4268"/>
                  <a:pt x="0" y="18288"/>
                </a:cubicBezTo>
                <a:cubicBezTo>
                  <a:pt x="766" y="10800"/>
                  <a:pt x="-457" y="818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1275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2727557108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ABE0DB6E-02EA-CD2F-573F-76B571D7FD56}"/>
              </a:ext>
            </a:extLst>
          </p:cNvPr>
          <p:cNvSpPr txBox="1"/>
          <p:nvPr/>
        </p:nvSpPr>
        <p:spPr>
          <a:xfrm>
            <a:off x="640080" y="2706624"/>
            <a:ext cx="6894576" cy="34838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000" dirty="0"/>
              <a:t>Two experienced clinicians manually annotated </a:t>
            </a:r>
            <a:r>
              <a:rPr lang="en-US" sz="2000" dirty="0" err="1"/>
              <a:t>EMGdi</a:t>
            </a:r>
            <a:r>
              <a:rPr lang="en-US" sz="2000" dirty="0"/>
              <a:t> onset and offset using an interface showing: (</a:t>
            </a:r>
            <a:r>
              <a:rPr lang="en-US" sz="2000" dirty="0" err="1"/>
              <a:t>i</a:t>
            </a:r>
            <a:r>
              <a:rPr lang="en-US" sz="2000" dirty="0"/>
              <a:t>) </a:t>
            </a:r>
            <a:r>
              <a:rPr lang="en-US" sz="2000" dirty="0" err="1"/>
              <a:t>EMGdi</a:t>
            </a:r>
            <a:r>
              <a:rPr lang="en-US" sz="2000" dirty="0"/>
              <a:t> band-pass (5-200 Hz), (ii) </a:t>
            </a:r>
            <a:r>
              <a:rPr lang="en-US" sz="2000" dirty="0" err="1"/>
              <a:t>EMGdi</a:t>
            </a:r>
            <a:r>
              <a:rPr lang="en-US" sz="2000" dirty="0"/>
              <a:t> high-pass (50 Hz) to improve visibility during ECG contamination, and (iii) airway pressure (context only)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000" dirty="0"/>
              <a:t>Events were considered reliable when the inter-scorer difference was less than 150 </a:t>
            </a:r>
            <a:r>
              <a:rPr lang="en-US" sz="2000" dirty="0" err="1"/>
              <a:t>ms.</a:t>
            </a:r>
            <a:endParaRPr lang="en-US" sz="2000" dirty="0"/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2000" dirty="0"/>
              <a:t>The examples illustrate: (1) high agreement (nearly identical onset/offset) and (2) a larger disagreement, where the onset is non-reliable (greater than 150 </a:t>
            </a:r>
            <a:r>
              <a:rPr lang="en-US" sz="2000" dirty="0" err="1"/>
              <a:t>ms</a:t>
            </a:r>
            <a:r>
              <a:rPr lang="en-US" sz="2000" dirty="0"/>
              <a:t>) while the offset remains reliable (less than 150 </a:t>
            </a:r>
            <a:r>
              <a:rPr lang="en-US" sz="2000" dirty="0" err="1"/>
              <a:t>ms</a:t>
            </a:r>
            <a:r>
              <a:rPr lang="en-US" sz="2000" dirty="0"/>
              <a:t>).</a:t>
            </a:r>
          </a:p>
        </p:txBody>
      </p:sp>
      <p:pic>
        <p:nvPicPr>
          <p:cNvPr id="8" name="Imagen 7" descr="Interfaz de usuario gráfica&#10;&#10;El contenido generado por IA puede ser incorrecto.">
            <a:extLst>
              <a:ext uri="{FF2B5EF4-FFF2-40B4-BE49-F238E27FC236}">
                <a16:creationId xmlns:a16="http://schemas.microsoft.com/office/drawing/2014/main" id="{B9ADB0D3-E4BA-6EB6-A669-2A235C4D8F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1301" y="366416"/>
            <a:ext cx="4688595" cy="2965536"/>
          </a:xfrm>
          <a:prstGeom prst="rect">
            <a:avLst/>
          </a:prstGeom>
        </p:spPr>
      </p:pic>
      <p:pic>
        <p:nvPicPr>
          <p:cNvPr id="5" name="Imagen 4" descr="Imagen que contiene Interfaz de usuario gráfica&#10;&#10;El contenido generado por IA puede ser incorrecto.">
            <a:extLst>
              <a:ext uri="{FF2B5EF4-FFF2-40B4-BE49-F238E27FC236}">
                <a16:creationId xmlns:a16="http://schemas.microsoft.com/office/drawing/2014/main" id="{FE2E0DE7-2F4B-0FD0-8806-FD7C79F398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71301" y="3661792"/>
            <a:ext cx="4717143" cy="2971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0666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BEF58345-2277-D9EA-333D-416D207B1B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7" name="Rectangle 26">
            <a:extLst>
              <a:ext uri="{FF2B5EF4-FFF2-40B4-BE49-F238E27FC236}">
                <a16:creationId xmlns:a16="http://schemas.microsoft.com/office/drawing/2014/main" id="{69D47016-023F-44BD-981C-50E7A10A660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89520401-AC05-DA80-064E-3519FED47351}"/>
              </a:ext>
            </a:extLst>
          </p:cNvPr>
          <p:cNvSpPr txBox="1"/>
          <p:nvPr/>
        </p:nvSpPr>
        <p:spPr>
          <a:xfrm>
            <a:off x="630936" y="457200"/>
            <a:ext cx="4343400" cy="1929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3000" b="1">
                <a:latin typeface="+mj-lt"/>
                <a:ea typeface="+mj-ea"/>
                <a:cs typeface="+mj-cs"/>
              </a:rPr>
              <a:t>Appendix B – ECG removal methods: gating reconstruction + wavelet truncation (schematic)</a:t>
            </a:r>
          </a:p>
        </p:txBody>
      </p:sp>
      <p:sp>
        <p:nvSpPr>
          <p:cNvPr id="29" name="sketchy line">
            <a:extLst>
              <a:ext uri="{FF2B5EF4-FFF2-40B4-BE49-F238E27FC236}">
                <a16:creationId xmlns:a16="http://schemas.microsoft.com/office/drawing/2014/main" id="{6D8B37B0-0682-433E-BC8D-498C04ABD9A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4471415" y="1412748"/>
            <a:ext cx="1554480" cy="18288"/>
          </a:xfrm>
          <a:custGeom>
            <a:avLst/>
            <a:gdLst>
              <a:gd name="csX0" fmla="*/ 0 w 1554480"/>
              <a:gd name="csY0" fmla="*/ 0 h 18288"/>
              <a:gd name="csX1" fmla="*/ 549250 w 1554480"/>
              <a:gd name="csY1" fmla="*/ 0 h 18288"/>
              <a:gd name="csX2" fmla="*/ 1082954 w 1554480"/>
              <a:gd name="csY2" fmla="*/ 0 h 18288"/>
              <a:gd name="csX3" fmla="*/ 1554480 w 1554480"/>
              <a:gd name="csY3" fmla="*/ 0 h 18288"/>
              <a:gd name="csX4" fmla="*/ 1554480 w 1554480"/>
              <a:gd name="csY4" fmla="*/ 18288 h 18288"/>
              <a:gd name="csX5" fmla="*/ 1067410 w 1554480"/>
              <a:gd name="csY5" fmla="*/ 18288 h 18288"/>
              <a:gd name="csX6" fmla="*/ 549250 w 1554480"/>
              <a:gd name="csY6" fmla="*/ 18288 h 18288"/>
              <a:gd name="csX7" fmla="*/ 0 w 1554480"/>
              <a:gd name="csY7" fmla="*/ 18288 h 18288"/>
              <a:gd name="csX8" fmla="*/ 0 w 1554480"/>
              <a:gd name="csY8" fmla="*/ 0 h 18288"/>
            </a:gdLst>
            <a:ahLst/>
            <a:cxnLst>
              <a:cxn ang="0">
                <a:pos x="csX0" y="csY0"/>
              </a:cxn>
              <a:cxn ang="0">
                <a:pos x="csX1" y="csY1"/>
              </a:cxn>
              <a:cxn ang="0">
                <a:pos x="csX2" y="csY2"/>
              </a:cxn>
              <a:cxn ang="0">
                <a:pos x="csX3" y="csY3"/>
              </a:cxn>
              <a:cxn ang="0">
                <a:pos x="csX4" y="csY4"/>
              </a:cxn>
              <a:cxn ang="0">
                <a:pos x="csX5" y="csY5"/>
              </a:cxn>
              <a:cxn ang="0">
                <a:pos x="csX6" y="csY6"/>
              </a:cxn>
              <a:cxn ang="0">
                <a:pos x="csX7" y="csY7"/>
              </a:cxn>
              <a:cxn ang="0">
                <a:pos x="csX8" y="csY8"/>
              </a:cxn>
            </a:cxnLst>
            <a:rect l="l" t="t" r="r" b="b"/>
            <a:pathLst>
              <a:path w="1554480" h="18288" fill="none" extrusionOk="0">
                <a:moveTo>
                  <a:pt x="0" y="0"/>
                </a:moveTo>
                <a:cubicBezTo>
                  <a:pt x="114141" y="-19864"/>
                  <a:pt x="345055" y="-1657"/>
                  <a:pt x="549250" y="0"/>
                </a:cubicBezTo>
                <a:cubicBezTo>
                  <a:pt x="753445" y="1657"/>
                  <a:pt x="862292" y="-5674"/>
                  <a:pt x="1082954" y="0"/>
                </a:cubicBezTo>
                <a:cubicBezTo>
                  <a:pt x="1303616" y="5674"/>
                  <a:pt x="1363530" y="4537"/>
                  <a:pt x="1554480" y="0"/>
                </a:cubicBezTo>
                <a:cubicBezTo>
                  <a:pt x="1554963" y="7176"/>
                  <a:pt x="1553909" y="13682"/>
                  <a:pt x="1554480" y="18288"/>
                </a:cubicBezTo>
                <a:cubicBezTo>
                  <a:pt x="1338847" y="6127"/>
                  <a:pt x="1215066" y="37851"/>
                  <a:pt x="1067410" y="18288"/>
                </a:cubicBezTo>
                <a:cubicBezTo>
                  <a:pt x="919754" y="-1275"/>
                  <a:pt x="800465" y="3080"/>
                  <a:pt x="549250" y="18288"/>
                </a:cubicBezTo>
                <a:cubicBezTo>
                  <a:pt x="298035" y="33496"/>
                  <a:pt x="158868" y="22769"/>
                  <a:pt x="0" y="18288"/>
                </a:cubicBezTo>
                <a:cubicBezTo>
                  <a:pt x="-655" y="13237"/>
                  <a:pt x="709" y="4645"/>
                  <a:pt x="0" y="0"/>
                </a:cubicBezTo>
                <a:close/>
              </a:path>
              <a:path w="1554480" h="18288" stroke="0" extrusionOk="0">
                <a:moveTo>
                  <a:pt x="0" y="0"/>
                </a:moveTo>
                <a:cubicBezTo>
                  <a:pt x="249941" y="-58"/>
                  <a:pt x="367334" y="23448"/>
                  <a:pt x="502615" y="0"/>
                </a:cubicBezTo>
                <a:cubicBezTo>
                  <a:pt x="637897" y="-23448"/>
                  <a:pt x="813653" y="-20418"/>
                  <a:pt x="974141" y="0"/>
                </a:cubicBezTo>
                <a:cubicBezTo>
                  <a:pt x="1134629" y="20418"/>
                  <a:pt x="1268772" y="6288"/>
                  <a:pt x="1554480" y="0"/>
                </a:cubicBezTo>
                <a:cubicBezTo>
                  <a:pt x="1554917" y="7222"/>
                  <a:pt x="1555359" y="13299"/>
                  <a:pt x="1554480" y="18288"/>
                </a:cubicBezTo>
                <a:cubicBezTo>
                  <a:pt x="1336087" y="12172"/>
                  <a:pt x="1310024" y="19759"/>
                  <a:pt x="1067410" y="18288"/>
                </a:cubicBezTo>
                <a:cubicBezTo>
                  <a:pt x="824796" y="16818"/>
                  <a:pt x="787902" y="34647"/>
                  <a:pt x="518160" y="18288"/>
                </a:cubicBezTo>
                <a:cubicBezTo>
                  <a:pt x="248418" y="1930"/>
                  <a:pt x="133160" y="9205"/>
                  <a:pt x="0" y="18288"/>
                </a:cubicBezTo>
                <a:cubicBezTo>
                  <a:pt x="-643" y="9451"/>
                  <a:pt x="-340" y="7114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1275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F85BD374-474B-8169-C8E2-508C3F5ECC67}"/>
              </a:ext>
            </a:extLst>
          </p:cNvPr>
          <p:cNvSpPr txBox="1"/>
          <p:nvPr/>
        </p:nvSpPr>
        <p:spPr>
          <a:xfrm>
            <a:off x="5541263" y="457200"/>
            <a:ext cx="6007608" cy="1929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/>
              <a:t>Discrete wavelet transform (Daubechies-4), 4-level decomposition, with adaptive thresholds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/>
              <a:t>Detail coefficients D1-D4 are thresholded (shrink/zero), then the EMGdi is reconstructed as Rec.det.1-4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/>
              <a:t>The level-4 approximation (A4) is discarded, effectively acting like a high-pass cutoff ~15.6 Hz (per filter responses)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200"/>
              <a:t>Because thresholding acts on coefficients, the method is nonlinear and can locally truncate/distort morphology, while suppressing QRS-related energy.</a:t>
            </a:r>
          </a:p>
        </p:txBody>
      </p:sp>
      <p:pic>
        <p:nvPicPr>
          <p:cNvPr id="9" name="Imagen 8" descr="Diagrama&#10;&#10;El contenido generado por IA puede ser incorrecto.">
            <a:extLst>
              <a:ext uri="{FF2B5EF4-FFF2-40B4-BE49-F238E27FC236}">
                <a16:creationId xmlns:a16="http://schemas.microsoft.com/office/drawing/2014/main" id="{7158D1CA-3191-08D9-1EE9-0D6EA01DE61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306" y="2843784"/>
            <a:ext cx="4660697" cy="3029453"/>
          </a:xfrm>
          <a:prstGeom prst="rect">
            <a:avLst/>
          </a:prstGeom>
        </p:spPr>
      </p:pic>
      <p:pic>
        <p:nvPicPr>
          <p:cNvPr id="6" name="Imagen 5" descr="Diagrama&#10;&#10;El contenido generado por IA puede ser incorrecto.">
            <a:extLst>
              <a:ext uri="{FF2B5EF4-FFF2-40B4-BE49-F238E27FC236}">
                <a16:creationId xmlns:a16="http://schemas.microsoft.com/office/drawing/2014/main" id="{4D9DC8CF-73E6-C9FC-8D1B-E9CC8932FCC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1" r="4373"/>
          <a:stretch>
            <a:fillRect/>
          </a:stretch>
        </p:blipFill>
        <p:spPr>
          <a:xfrm>
            <a:off x="5609327" y="2234293"/>
            <a:ext cx="6007607" cy="4474248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B47FCDE7-3CB8-DF8F-01B0-46DAF88AAC5B}"/>
              </a:ext>
            </a:extLst>
          </p:cNvPr>
          <p:cNvSpPr txBox="1"/>
          <p:nvPr/>
        </p:nvSpPr>
        <p:spPr>
          <a:xfrm>
            <a:off x="9544050" y="25717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220291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9DA363BA-0CA4-4AB7-EA51-3033DFAA9D2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37" name="Rectangle 26">
            <a:extLst>
              <a:ext uri="{FF2B5EF4-FFF2-40B4-BE49-F238E27FC236}">
                <a16:creationId xmlns:a16="http://schemas.microsoft.com/office/drawing/2014/main" id="{2B97F24A-32CE-4C1C-A50D-3016B394DCF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8EB096CF-5A50-3D31-B5A1-8D6FC56DF59E}"/>
              </a:ext>
            </a:extLst>
          </p:cNvPr>
          <p:cNvSpPr txBox="1"/>
          <p:nvPr/>
        </p:nvSpPr>
        <p:spPr>
          <a:xfrm>
            <a:off x="263352" y="702392"/>
            <a:ext cx="3796584" cy="165620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2200" b="1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Appendix B – ECG removal methods: gating reconstruction + wavelet truncation (schematic)</a:t>
            </a:r>
          </a:p>
        </p:txBody>
      </p:sp>
      <p:sp>
        <p:nvSpPr>
          <p:cNvPr id="38" name="sketch line">
            <a:extLst>
              <a:ext uri="{FF2B5EF4-FFF2-40B4-BE49-F238E27FC236}">
                <a16:creationId xmlns:a16="http://schemas.microsoft.com/office/drawing/2014/main" id="{CD8B4F24-440B-49E9-B85D-733523DC064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2573756"/>
            <a:ext cx="3255095" cy="18288"/>
          </a:xfrm>
          <a:custGeom>
            <a:avLst/>
            <a:gdLst>
              <a:gd name="csX0" fmla="*/ 0 w 3255095"/>
              <a:gd name="csY0" fmla="*/ 0 h 18288"/>
              <a:gd name="csX1" fmla="*/ 618468 w 3255095"/>
              <a:gd name="csY1" fmla="*/ 0 h 18288"/>
              <a:gd name="csX2" fmla="*/ 1269487 w 3255095"/>
              <a:gd name="csY2" fmla="*/ 0 h 18288"/>
              <a:gd name="csX3" fmla="*/ 1953057 w 3255095"/>
              <a:gd name="csY3" fmla="*/ 0 h 18288"/>
              <a:gd name="csX4" fmla="*/ 2636627 w 3255095"/>
              <a:gd name="csY4" fmla="*/ 0 h 18288"/>
              <a:gd name="csX5" fmla="*/ 3255095 w 3255095"/>
              <a:gd name="csY5" fmla="*/ 0 h 18288"/>
              <a:gd name="csX6" fmla="*/ 3255095 w 3255095"/>
              <a:gd name="csY6" fmla="*/ 18288 h 18288"/>
              <a:gd name="csX7" fmla="*/ 2538974 w 3255095"/>
              <a:gd name="csY7" fmla="*/ 18288 h 18288"/>
              <a:gd name="csX8" fmla="*/ 1822853 w 3255095"/>
              <a:gd name="csY8" fmla="*/ 18288 h 18288"/>
              <a:gd name="csX9" fmla="*/ 1171834 w 3255095"/>
              <a:gd name="csY9" fmla="*/ 18288 h 18288"/>
              <a:gd name="csX10" fmla="*/ 0 w 3255095"/>
              <a:gd name="csY10" fmla="*/ 18288 h 18288"/>
              <a:gd name="csX11" fmla="*/ 0 w 3255095"/>
              <a:gd name="csY11" fmla="*/ 0 h 18288"/>
            </a:gdLst>
            <a:ahLst/>
            <a:cxnLst>
              <a:cxn ang="0">
                <a:pos x="csX0" y="csY0"/>
              </a:cxn>
              <a:cxn ang="0">
                <a:pos x="csX1" y="csY1"/>
              </a:cxn>
              <a:cxn ang="0">
                <a:pos x="csX2" y="csY2"/>
              </a:cxn>
              <a:cxn ang="0">
                <a:pos x="csX3" y="csY3"/>
              </a:cxn>
              <a:cxn ang="0">
                <a:pos x="csX4" y="csY4"/>
              </a:cxn>
              <a:cxn ang="0">
                <a:pos x="csX5" y="csY5"/>
              </a:cxn>
              <a:cxn ang="0">
                <a:pos x="csX6" y="csY6"/>
              </a:cxn>
              <a:cxn ang="0">
                <a:pos x="csX7" y="csY7"/>
              </a:cxn>
              <a:cxn ang="0">
                <a:pos x="csX8" y="csY8"/>
              </a:cxn>
              <a:cxn ang="0">
                <a:pos x="csX9" y="csY9"/>
              </a:cxn>
              <a:cxn ang="0">
                <a:pos x="csX10" y="csY10"/>
              </a:cxn>
              <a:cxn ang="0">
                <a:pos x="csX11" y="cs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E0274BE-E4C8-3A74-6CCC-25799A081F13}"/>
              </a:ext>
            </a:extLst>
          </p:cNvPr>
          <p:cNvSpPr txBox="1"/>
          <p:nvPr/>
        </p:nvSpPr>
        <p:spPr>
          <a:xfrm>
            <a:off x="263352" y="2785211"/>
            <a:ext cx="3796584" cy="364617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571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/>
              <a:t>Time-domain gating vs wavelet (same 10 s example)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000" dirty="0"/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Gating (time domain): detect R-peaks, define a 0.13 s window around each peak on </a:t>
            </a:r>
            <a:r>
              <a:rPr lang="en-US" sz="1000" dirty="0" err="1"/>
              <a:t>EMGdi</a:t>
            </a:r>
            <a:r>
              <a:rPr lang="en-US" sz="1000" dirty="0"/>
              <a:t>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Remove samples within the window and reconstruct using two adjacent 0.065 s RMS windows (pre/post), linear interpolation between RMS values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Preserves the inspiratory envelope shape, while suppressing sharp QRS transients.</a:t>
            </a:r>
          </a:p>
          <a:p>
            <a:pPr marL="571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/>
              <a:t>Practical difference (example)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000" dirty="0"/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Wavelet: truncates large QRS peaks but may leave residual energy when QRS overlaps </a:t>
            </a:r>
            <a:r>
              <a:rPr lang="en-US" sz="1000" dirty="0" err="1"/>
              <a:t>EMGdi</a:t>
            </a:r>
            <a:r>
              <a:rPr lang="en-US" sz="1000" dirty="0"/>
              <a:t> activity.</a:t>
            </a:r>
          </a:p>
          <a:p>
            <a:pPr marL="2857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Gating (after 45 Hz high-pass): removes more energy around R-peaks, producing cleaner envelopes (slightly less </a:t>
            </a:r>
            <a:r>
              <a:rPr lang="en-US" sz="1000" dirty="0" err="1"/>
              <a:t>EMGdi</a:t>
            </a:r>
            <a:r>
              <a:rPr lang="en-US" sz="1000" dirty="0"/>
              <a:t> energy), consistent with better onset/offset detection in our dataset.</a:t>
            </a:r>
          </a:p>
        </p:txBody>
      </p:sp>
      <p:pic>
        <p:nvPicPr>
          <p:cNvPr id="3" name="Imagen 2" descr="Imagen que contiene Escala de tiempo&#10;&#10;El contenido generado por IA puede ser incorrecto.">
            <a:extLst>
              <a:ext uri="{FF2B5EF4-FFF2-40B4-BE49-F238E27FC236}">
                <a16:creationId xmlns:a16="http://schemas.microsoft.com/office/drawing/2014/main" id="{A2CD40F8-7654-2667-9EFE-4CC80A31A6E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6182" y="702392"/>
            <a:ext cx="8389563" cy="5453216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34A3588F-93AB-1CA2-77ED-D16E32C9211A}"/>
              </a:ext>
            </a:extLst>
          </p:cNvPr>
          <p:cNvSpPr txBox="1"/>
          <p:nvPr/>
        </p:nvSpPr>
        <p:spPr>
          <a:xfrm>
            <a:off x="9544050" y="25717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9805822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0A59492A-351E-6572-D2D0-3487E8B3E1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43" name="Rectangle 42">
            <a:extLst>
              <a:ext uri="{FF2B5EF4-FFF2-40B4-BE49-F238E27FC236}">
                <a16:creationId xmlns:a16="http://schemas.microsoft.com/office/drawing/2014/main" id="{2B97F24A-32CE-4C1C-A50D-3016B394DCF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58F499A0-5654-DC79-F5D1-2D8E09AD47F3}"/>
              </a:ext>
            </a:extLst>
          </p:cNvPr>
          <p:cNvSpPr txBox="1"/>
          <p:nvPr/>
        </p:nvSpPr>
        <p:spPr>
          <a:xfrm>
            <a:off x="630936" y="639520"/>
            <a:ext cx="3429000" cy="171907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3000" b="1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Appendix C – I2BSNR estimation (per 30 s epoch)</a:t>
            </a:r>
          </a:p>
        </p:txBody>
      </p:sp>
      <p:sp>
        <p:nvSpPr>
          <p:cNvPr id="45" name="sketch line">
            <a:extLst>
              <a:ext uri="{FF2B5EF4-FFF2-40B4-BE49-F238E27FC236}">
                <a16:creationId xmlns:a16="http://schemas.microsoft.com/office/drawing/2014/main" id="{CD8B4F24-440B-49E9-B85D-733523DC064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2573756"/>
            <a:ext cx="3255095" cy="18288"/>
          </a:xfrm>
          <a:custGeom>
            <a:avLst/>
            <a:gdLst>
              <a:gd name="csX0" fmla="*/ 0 w 3255095"/>
              <a:gd name="csY0" fmla="*/ 0 h 18288"/>
              <a:gd name="csX1" fmla="*/ 618468 w 3255095"/>
              <a:gd name="csY1" fmla="*/ 0 h 18288"/>
              <a:gd name="csX2" fmla="*/ 1269487 w 3255095"/>
              <a:gd name="csY2" fmla="*/ 0 h 18288"/>
              <a:gd name="csX3" fmla="*/ 1953057 w 3255095"/>
              <a:gd name="csY3" fmla="*/ 0 h 18288"/>
              <a:gd name="csX4" fmla="*/ 2636627 w 3255095"/>
              <a:gd name="csY4" fmla="*/ 0 h 18288"/>
              <a:gd name="csX5" fmla="*/ 3255095 w 3255095"/>
              <a:gd name="csY5" fmla="*/ 0 h 18288"/>
              <a:gd name="csX6" fmla="*/ 3255095 w 3255095"/>
              <a:gd name="csY6" fmla="*/ 18288 h 18288"/>
              <a:gd name="csX7" fmla="*/ 2538974 w 3255095"/>
              <a:gd name="csY7" fmla="*/ 18288 h 18288"/>
              <a:gd name="csX8" fmla="*/ 1822853 w 3255095"/>
              <a:gd name="csY8" fmla="*/ 18288 h 18288"/>
              <a:gd name="csX9" fmla="*/ 1171834 w 3255095"/>
              <a:gd name="csY9" fmla="*/ 18288 h 18288"/>
              <a:gd name="csX10" fmla="*/ 0 w 3255095"/>
              <a:gd name="csY10" fmla="*/ 18288 h 18288"/>
              <a:gd name="csX11" fmla="*/ 0 w 3255095"/>
              <a:gd name="csY11" fmla="*/ 0 h 18288"/>
            </a:gdLst>
            <a:ahLst/>
            <a:cxnLst>
              <a:cxn ang="0">
                <a:pos x="csX0" y="csY0"/>
              </a:cxn>
              <a:cxn ang="0">
                <a:pos x="csX1" y="csY1"/>
              </a:cxn>
              <a:cxn ang="0">
                <a:pos x="csX2" y="csY2"/>
              </a:cxn>
              <a:cxn ang="0">
                <a:pos x="csX3" y="csY3"/>
              </a:cxn>
              <a:cxn ang="0">
                <a:pos x="csX4" y="csY4"/>
              </a:cxn>
              <a:cxn ang="0">
                <a:pos x="csX5" y="csY5"/>
              </a:cxn>
              <a:cxn ang="0">
                <a:pos x="csX6" y="csY6"/>
              </a:cxn>
              <a:cxn ang="0">
                <a:pos x="csX7" y="csY7"/>
              </a:cxn>
              <a:cxn ang="0">
                <a:pos x="csX8" y="csY8"/>
              </a:cxn>
              <a:cxn ang="0">
                <a:pos x="csX9" y="csY9"/>
              </a:cxn>
              <a:cxn ang="0">
                <a:pos x="csX10" y="csY10"/>
              </a:cxn>
              <a:cxn ang="0">
                <a:pos x="csX11" y="cs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7AD63949-4F7A-B0B7-B014-C518C9707860}"/>
              </a:ext>
            </a:extLst>
          </p:cNvPr>
          <p:cNvSpPr txBox="1"/>
          <p:nvPr/>
        </p:nvSpPr>
        <p:spPr>
          <a:xfrm>
            <a:off x="630936" y="2807208"/>
            <a:ext cx="3429000" cy="3410712"/>
          </a:xfrm>
          <a:prstGeom prst="rect">
            <a:avLst/>
          </a:prstGeom>
        </p:spPr>
        <p:txBody>
          <a:bodyPr vert="horz" lIns="91440" tIns="45720" rIns="91440" bIns="45720" rtlCol="0" anchor="t">
            <a:normAutofit lnSpcReduction="10000"/>
          </a:bodyPr>
          <a:lstStyle/>
          <a:p>
            <a:pPr marL="1714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/>
              <a:t>Preprocessing</a:t>
            </a:r>
            <a:r>
              <a:rPr lang="en-US" sz="1000" dirty="0"/>
              <a:t> (common to all recordings): </a:t>
            </a:r>
            <a:r>
              <a:rPr lang="en-US" sz="1000" dirty="0" err="1"/>
              <a:t>EMGdi</a:t>
            </a:r>
            <a:r>
              <a:rPr lang="en-US" sz="1000" dirty="0"/>
              <a:t> band-pass 5-200 Hz (4th-order, zero-phase) + adaptive 50 Hz notch, before applying any ECG-removal method.</a:t>
            </a:r>
          </a:p>
          <a:p>
            <a:pPr marL="1714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/>
              <a:t>Remove cardiac complexes</a:t>
            </a:r>
            <a:r>
              <a:rPr lang="en-US" sz="1000" dirty="0"/>
              <a:t>: detect R-peaks (Pan-Tompkins on </a:t>
            </a:r>
            <a:r>
              <a:rPr lang="en-US" sz="1000" dirty="0" err="1"/>
              <a:t>EMGdi</a:t>
            </a:r>
            <a:r>
              <a:rPr lang="en-US" sz="1000" dirty="0"/>
              <a:t> filtered 5-40 Hz). Discard samples in an ECG exclusion window of [-135 </a:t>
            </a:r>
            <a:r>
              <a:rPr lang="en-US" sz="1000" dirty="0" err="1"/>
              <a:t>ms</a:t>
            </a:r>
            <a:r>
              <a:rPr lang="en-US" sz="1000" dirty="0"/>
              <a:t>, +365 </a:t>
            </a:r>
            <a:r>
              <a:rPr lang="en-US" sz="1000" dirty="0" err="1"/>
              <a:t>ms</a:t>
            </a:r>
            <a:r>
              <a:rPr lang="en-US" sz="1000" dirty="0"/>
              <a:t>] around each R-peak.</a:t>
            </a:r>
          </a:p>
          <a:p>
            <a:pPr marL="1714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 err="1"/>
              <a:t>Epoching</a:t>
            </a:r>
            <a:r>
              <a:rPr lang="en-US" sz="1000" dirty="0"/>
              <a:t>: split each recording into consecutive 30 s epochs.</a:t>
            </a:r>
          </a:p>
          <a:p>
            <a:pPr marL="1714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/>
              <a:t>Segment selection </a:t>
            </a:r>
            <a:r>
              <a:rPr lang="en-US" sz="1000" dirty="0"/>
              <a:t>(within each epoch):</a:t>
            </a:r>
          </a:p>
          <a:p>
            <a:pPr marL="628650" lvl="1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Inspiratory segments: samples inside detected inspiratory intervals and outside ECG exclusion windows.</a:t>
            </a:r>
          </a:p>
          <a:p>
            <a:pPr marL="628650" lvl="1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Basal expiratory segments: remaining samples outside inspiratory intervals and outside ECG exclusion windows (noise reference).</a:t>
            </a:r>
          </a:p>
          <a:p>
            <a:pPr marL="17145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b="1" dirty="0"/>
              <a:t>Compute ratios</a:t>
            </a:r>
            <a:r>
              <a:rPr lang="en-US" sz="1000" dirty="0"/>
              <a:t>:</a:t>
            </a:r>
          </a:p>
          <a:p>
            <a:pPr marL="628650" lvl="1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 err="1"/>
              <a:t>R_inex</a:t>
            </a:r>
            <a:r>
              <a:rPr lang="en-US" sz="1000" dirty="0"/>
              <a:t> = </a:t>
            </a:r>
            <a:r>
              <a:rPr lang="en-US" sz="1000" dirty="0" err="1"/>
              <a:t>RMS_in</a:t>
            </a:r>
            <a:r>
              <a:rPr lang="en-US" sz="1000" dirty="0"/>
              <a:t>/</a:t>
            </a:r>
            <a:r>
              <a:rPr lang="en-US" sz="1000" dirty="0" err="1"/>
              <a:t>RMS_ex</a:t>
            </a:r>
            <a:r>
              <a:rPr lang="en-US" sz="1000" dirty="0"/>
              <a:t>, </a:t>
            </a:r>
          </a:p>
          <a:p>
            <a:pPr marL="628650" lvl="1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/>
              <a:t>I2BSNR (dB) = 20*log10(</a:t>
            </a:r>
            <a:r>
              <a:rPr lang="en-US" sz="1000" dirty="0" err="1"/>
              <a:t>R_inex</a:t>
            </a:r>
            <a:r>
              <a:rPr lang="en-US" sz="1000" dirty="0"/>
              <a:t>)</a:t>
            </a:r>
          </a:p>
          <a:p>
            <a:pPr marL="628650" lvl="1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000" dirty="0" err="1"/>
              <a:t>R_cardio</a:t>
            </a:r>
            <a:r>
              <a:rPr lang="en-US" sz="1000" dirty="0"/>
              <a:t> = </a:t>
            </a:r>
            <a:r>
              <a:rPr lang="en-US" sz="1000" dirty="0" err="1"/>
              <a:t>RMS_card</a:t>
            </a:r>
            <a:r>
              <a:rPr lang="en-US" sz="1000" dirty="0"/>
              <a:t> / </a:t>
            </a:r>
            <a:r>
              <a:rPr lang="en-US" sz="1000" dirty="0" err="1"/>
              <a:t>RMS_ex</a:t>
            </a:r>
            <a:endParaRPr lang="en-US" sz="1000" dirty="0"/>
          </a:p>
        </p:txBody>
      </p:sp>
      <p:pic>
        <p:nvPicPr>
          <p:cNvPr id="6" name="Imagen 5" descr="Gráfico&#10;&#10;El contenido generado por IA puede ser incorrecto.">
            <a:extLst>
              <a:ext uri="{FF2B5EF4-FFF2-40B4-BE49-F238E27FC236}">
                <a16:creationId xmlns:a16="http://schemas.microsoft.com/office/drawing/2014/main" id="{8F1D00DE-3D79-2BBE-841E-6B1FCC9BB9F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8632" y="981282"/>
            <a:ext cx="7992550" cy="4895436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D65E08F6-82AA-FF58-DA5D-2684DD20DAF6}"/>
              </a:ext>
            </a:extLst>
          </p:cNvPr>
          <p:cNvSpPr txBox="1"/>
          <p:nvPr/>
        </p:nvSpPr>
        <p:spPr>
          <a:xfrm>
            <a:off x="9544050" y="25717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767186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ECA3CDEC-E6F6-8126-F6E3-7298ED4A34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4" name="Rectangle 49">
            <a:extLst>
              <a:ext uri="{FF2B5EF4-FFF2-40B4-BE49-F238E27FC236}">
                <a16:creationId xmlns:a16="http://schemas.microsoft.com/office/drawing/2014/main" id="{8F7AFB9A-7364-478C-B48B-8523CDD9AE8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75" name="Freeform: Shape 51">
            <a:extLst>
              <a:ext uri="{FF2B5EF4-FFF2-40B4-BE49-F238E27FC236}">
                <a16:creationId xmlns:a16="http://schemas.microsoft.com/office/drawing/2014/main" id="{36678033-86B6-40E6-BE90-78D8ED4E3A3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6096002" cy="6858000"/>
          </a:xfrm>
          <a:custGeom>
            <a:avLst/>
            <a:gdLst>
              <a:gd name="connsiteX0" fmla="*/ 0 w 6096002"/>
              <a:gd name="connsiteY0" fmla="*/ 0 h 6858000"/>
              <a:gd name="connsiteX1" fmla="*/ 4885967 w 6096002"/>
              <a:gd name="connsiteY1" fmla="*/ 0 h 6858000"/>
              <a:gd name="connsiteX2" fmla="*/ 4946007 w 6096002"/>
              <a:gd name="connsiteY2" fmla="*/ 69271 h 6858000"/>
              <a:gd name="connsiteX3" fmla="*/ 6096002 w 6096002"/>
              <a:gd name="connsiteY3" fmla="*/ 3429000 h 6858000"/>
              <a:gd name="connsiteX4" fmla="*/ 4946007 w 6096002"/>
              <a:gd name="connsiteY4" fmla="*/ 6788730 h 6858000"/>
              <a:gd name="connsiteX5" fmla="*/ 4885967 w 6096002"/>
              <a:gd name="connsiteY5" fmla="*/ 6858000 h 6858000"/>
              <a:gd name="connsiteX6" fmla="*/ 0 w 6096002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96002" h="6858000">
                <a:moveTo>
                  <a:pt x="0" y="0"/>
                </a:moveTo>
                <a:lnTo>
                  <a:pt x="4885967" y="0"/>
                </a:lnTo>
                <a:lnTo>
                  <a:pt x="4946007" y="69271"/>
                </a:lnTo>
                <a:cubicBezTo>
                  <a:pt x="5656533" y="929100"/>
                  <a:pt x="6096002" y="2116944"/>
                  <a:pt x="6096002" y="3429000"/>
                </a:cubicBezTo>
                <a:cubicBezTo>
                  <a:pt x="6096002" y="4741056"/>
                  <a:pt x="5656533" y="5928900"/>
                  <a:pt x="4946007" y="6788730"/>
                </a:cubicBezTo>
                <a:lnTo>
                  <a:pt x="4885967" y="6858000"/>
                </a:lnTo>
                <a:lnTo>
                  <a:pt x="0" y="6858000"/>
                </a:lnTo>
                <a:close/>
              </a:path>
            </a:pathLst>
          </a:custGeom>
          <a:ln w="9525">
            <a:solidFill>
              <a:srgbClr val="EFEFEF"/>
            </a:solidFill>
          </a:ln>
          <a:effectLst>
            <a:outerShdw blurRad="88900" dist="38100" algn="l" rotWithShape="0">
              <a:schemeClr val="bg1">
                <a:lumMod val="85000"/>
                <a:alpha val="50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76" name="Freeform: Shape 53">
            <a:extLst>
              <a:ext uri="{FF2B5EF4-FFF2-40B4-BE49-F238E27FC236}">
                <a16:creationId xmlns:a16="http://schemas.microsoft.com/office/drawing/2014/main" id="{D2542E1A-076E-4A34-BB67-2BF961754E0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6085370" cy="6858000"/>
          </a:xfrm>
          <a:custGeom>
            <a:avLst/>
            <a:gdLst>
              <a:gd name="connsiteX0" fmla="*/ 0 w 6085370"/>
              <a:gd name="connsiteY0" fmla="*/ 0 h 6858000"/>
              <a:gd name="connsiteX1" fmla="*/ 4875335 w 6085370"/>
              <a:gd name="connsiteY1" fmla="*/ 0 h 6858000"/>
              <a:gd name="connsiteX2" fmla="*/ 4935375 w 6085370"/>
              <a:gd name="connsiteY2" fmla="*/ 69271 h 6858000"/>
              <a:gd name="connsiteX3" fmla="*/ 6085370 w 6085370"/>
              <a:gd name="connsiteY3" fmla="*/ 3429000 h 6858000"/>
              <a:gd name="connsiteX4" fmla="*/ 4935375 w 6085370"/>
              <a:gd name="connsiteY4" fmla="*/ 6788730 h 6858000"/>
              <a:gd name="connsiteX5" fmla="*/ 4875335 w 6085370"/>
              <a:gd name="connsiteY5" fmla="*/ 6858000 h 6858000"/>
              <a:gd name="connsiteX6" fmla="*/ 0 w 6085370"/>
              <a:gd name="connsiteY6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6085370" h="6858000">
                <a:moveTo>
                  <a:pt x="0" y="0"/>
                </a:moveTo>
                <a:lnTo>
                  <a:pt x="4875335" y="0"/>
                </a:lnTo>
                <a:lnTo>
                  <a:pt x="4935375" y="69271"/>
                </a:lnTo>
                <a:cubicBezTo>
                  <a:pt x="5645901" y="929100"/>
                  <a:pt x="6085370" y="2116944"/>
                  <a:pt x="6085370" y="3429000"/>
                </a:cubicBezTo>
                <a:cubicBezTo>
                  <a:pt x="6085370" y="4741056"/>
                  <a:pt x="5645901" y="5928900"/>
                  <a:pt x="4935375" y="6788730"/>
                </a:cubicBezTo>
                <a:lnTo>
                  <a:pt x="4875335" y="6858000"/>
                </a:lnTo>
                <a:lnTo>
                  <a:pt x="0" y="6858000"/>
                </a:lnTo>
                <a:close/>
              </a:path>
            </a:pathLst>
          </a:cu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66EF2C98-1556-6DE5-90AE-9FC18F67AD1C}"/>
              </a:ext>
            </a:extLst>
          </p:cNvPr>
          <p:cNvSpPr txBox="1"/>
          <p:nvPr/>
        </p:nvSpPr>
        <p:spPr>
          <a:xfrm>
            <a:off x="438913" y="859536"/>
            <a:ext cx="4832802" cy="12435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3400" b="1">
                <a:latin typeface="+mj-lt"/>
                <a:ea typeface="+mj-ea"/>
                <a:cs typeface="+mj-cs"/>
              </a:rPr>
              <a:t>Appendix D – Reliable events (&lt;150 ms)</a:t>
            </a:r>
          </a:p>
        </p:txBody>
      </p:sp>
      <p:sp>
        <p:nvSpPr>
          <p:cNvPr id="77" name="Rectangle 55">
            <a:extLst>
              <a:ext uri="{FF2B5EF4-FFF2-40B4-BE49-F238E27FC236}">
                <a16:creationId xmlns:a16="http://schemas.microsoft.com/office/drawing/2014/main" id="{75C56826-D4E5-42ED-8529-079651CB300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1152144"/>
            <a:ext cx="128016" cy="653903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78" name="Rectangle 57">
            <a:extLst>
              <a:ext uri="{FF2B5EF4-FFF2-40B4-BE49-F238E27FC236}">
                <a16:creationId xmlns:a16="http://schemas.microsoft.com/office/drawing/2014/main" id="{82095FCE-EF05-4443-B97A-85DEE3A5CA1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38912" y="2185062"/>
            <a:ext cx="4983480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C5A49EE6-B94C-FDA8-DDA0-3377B4636BD5}"/>
              </a:ext>
            </a:extLst>
          </p:cNvPr>
          <p:cNvSpPr txBox="1"/>
          <p:nvPr/>
        </p:nvSpPr>
        <p:spPr>
          <a:xfrm>
            <a:off x="182370" y="2512611"/>
            <a:ext cx="4761503" cy="3741845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10000"/>
          </a:bodyPr>
          <a:lstStyle/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The detector was applied to the entire 1-hour home NIV recordings (no pre-selection of “good-quality” segments).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The 150 </a:t>
            </a:r>
            <a:r>
              <a:rPr lang="en-US" sz="1400" dirty="0" err="1"/>
              <a:t>ms</a:t>
            </a:r>
            <a:r>
              <a:rPr lang="en-US" sz="1400" dirty="0"/>
              <a:t> threshold was used only to define a reliable human reference for timing evaluation.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Two-step reference definition: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marL="22860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Agreed events: inspiratory intervals annotated by both scorers with temporal overlap.</a:t>
            </a:r>
          </a:p>
          <a:p>
            <a:pPr marL="22860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marL="228600"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Reliable timing: within agreed events, onsets and offsets are assessed separately and are considered reliable when inter-scorer difference is &lt;150 </a:t>
            </a:r>
            <a:r>
              <a:rPr lang="en-US" sz="1400" dirty="0" err="1"/>
              <a:t>ms.</a:t>
            </a: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Therefore, a cycle may contribute a reliable onset but an unreliable offset (or vice versa), which explains why the number of evaluated onsets and offsets differs.</a:t>
            </a:r>
          </a:p>
        </p:txBody>
      </p:sp>
      <p:pic>
        <p:nvPicPr>
          <p:cNvPr id="3" name="Imagen 2" descr="Tabla&#10;&#10;El contenido generado por IA puede ser incorrecto.">
            <a:extLst>
              <a:ext uri="{FF2B5EF4-FFF2-40B4-BE49-F238E27FC236}">
                <a16:creationId xmlns:a16="http://schemas.microsoft.com/office/drawing/2014/main" id="{83305F24-FF3E-C908-3AEC-8F2BAB3C08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3873" y="1887964"/>
            <a:ext cx="7248127" cy="1449624"/>
          </a:xfrm>
          <a:prstGeom prst="rect">
            <a:avLst/>
          </a:prstGeom>
        </p:spPr>
      </p:pic>
      <p:pic>
        <p:nvPicPr>
          <p:cNvPr id="5" name="Imagen 4" descr="Tabla&#10;&#10;El contenido generado por IA puede ser incorrecto.">
            <a:extLst>
              <a:ext uri="{FF2B5EF4-FFF2-40B4-BE49-F238E27FC236}">
                <a16:creationId xmlns:a16="http://schemas.microsoft.com/office/drawing/2014/main" id="{E5A50703-0C08-6F38-8BAB-F38FA0E95E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43873" y="4040022"/>
            <a:ext cx="7173431" cy="1362951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20AA3502-B6C0-7C2D-11B1-44D9C8448D92}"/>
              </a:ext>
            </a:extLst>
          </p:cNvPr>
          <p:cNvSpPr txBox="1"/>
          <p:nvPr/>
        </p:nvSpPr>
        <p:spPr>
          <a:xfrm>
            <a:off x="9544050" y="25717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B7ADEB0B-C7B5-4E3A-48BA-A9A00CE3B654}"/>
              </a:ext>
            </a:extLst>
          </p:cNvPr>
          <p:cNvSpPr txBox="1"/>
          <p:nvPr/>
        </p:nvSpPr>
        <p:spPr>
          <a:xfrm>
            <a:off x="5271715" y="3573016"/>
            <a:ext cx="6121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MSD between experts without 15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restriction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53415A63-AAE3-4108-C3C0-C36D1AECD7DE}"/>
              </a:ext>
            </a:extLst>
          </p:cNvPr>
          <p:cNvSpPr txBox="1"/>
          <p:nvPr/>
        </p:nvSpPr>
        <p:spPr>
          <a:xfrm>
            <a:off x="5271715" y="1155929"/>
            <a:ext cx="6121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MSD between experts restricted to onsets and offsets that satisfied the 15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greement criterion</a:t>
            </a:r>
            <a:r>
              <a:rPr lang="es-ES" dirty="0">
                <a:effectLst/>
              </a:rPr>
              <a:t>  (Table III)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1272917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E28E22-6C6D-66A6-E393-4561F41806D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A3A184DA-56F6-F4FB-F5C5-BBFB40D64202}"/>
              </a:ext>
            </a:extLst>
          </p:cNvPr>
          <p:cNvSpPr txBox="1"/>
          <p:nvPr/>
        </p:nvSpPr>
        <p:spPr>
          <a:xfrm>
            <a:off x="438913" y="859536"/>
            <a:ext cx="4832802" cy="12435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3400" b="1">
                <a:latin typeface="+mj-lt"/>
                <a:ea typeface="+mj-ea"/>
                <a:cs typeface="+mj-cs"/>
              </a:rPr>
              <a:t>Appendix D – Reliable events (&lt;150 ms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9136BBE7-DA87-D804-CF13-3A2F1D526846}"/>
              </a:ext>
            </a:extLst>
          </p:cNvPr>
          <p:cNvSpPr txBox="1"/>
          <p:nvPr/>
        </p:nvSpPr>
        <p:spPr>
          <a:xfrm>
            <a:off x="182370" y="2512611"/>
            <a:ext cx="4761503" cy="37418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We recomputed event-detection performance using all events annotated by at least one scorer (union of both annotation sets), including scorer-specific/ambiguous cycles.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As expected, sensitivity and F1-score decrease moderately, but the algorithm ranking remains unchanged.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This confirms that our conclusions do not depend on restricting the reference to agreed events, while the “reliable events” analysis avoids benchmarking against an uncertain human reference.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6841B5A5-E12D-93E2-3282-16673C0415FE}"/>
              </a:ext>
            </a:extLst>
          </p:cNvPr>
          <p:cNvSpPr txBox="1"/>
          <p:nvPr/>
        </p:nvSpPr>
        <p:spPr>
          <a:xfrm>
            <a:off x="9544050" y="306896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2FB12A1-9679-44E9-E0FF-0FD056C3EF1E}"/>
              </a:ext>
            </a:extLst>
          </p:cNvPr>
          <p:cNvSpPr txBox="1"/>
          <p:nvPr/>
        </p:nvSpPr>
        <p:spPr>
          <a:xfrm>
            <a:off x="5271715" y="4006805"/>
            <a:ext cx="6121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1-score using all events</a:t>
            </a:r>
            <a:endParaRPr lang="es-ES" dirty="0"/>
          </a:p>
        </p:txBody>
      </p:sp>
      <p:pic>
        <p:nvPicPr>
          <p:cNvPr id="6" name="Imagen 5" descr="Tabla&#10;&#10;El contenido generado por IA puede ser incorrecto.">
            <a:extLst>
              <a:ext uri="{FF2B5EF4-FFF2-40B4-BE49-F238E27FC236}">
                <a16:creationId xmlns:a16="http://schemas.microsoft.com/office/drawing/2014/main" id="{6666E769-569E-A850-0DEB-2C065A1F91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8890" y="1875353"/>
            <a:ext cx="7319996" cy="1998523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9E1CBA76-67D1-68BC-4542-6FB55A2A7CE6}"/>
              </a:ext>
            </a:extLst>
          </p:cNvPr>
          <p:cNvSpPr txBox="1"/>
          <p:nvPr/>
        </p:nvSpPr>
        <p:spPr>
          <a:xfrm>
            <a:off x="5271715" y="1155929"/>
            <a:ext cx="6121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1-score using only reliable events with the 15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greement criterion</a:t>
            </a:r>
            <a:r>
              <a:rPr lang="es-ES" dirty="0">
                <a:effectLst/>
              </a:rPr>
              <a:t>  (Table IV)</a:t>
            </a:r>
            <a:endParaRPr lang="es-ES" dirty="0"/>
          </a:p>
        </p:txBody>
      </p:sp>
      <p:pic>
        <p:nvPicPr>
          <p:cNvPr id="9" name="Imagen 8" descr="Tabla&#10;&#10;El contenido generado por IA puede ser incorrecto.">
            <a:extLst>
              <a:ext uri="{FF2B5EF4-FFF2-40B4-BE49-F238E27FC236}">
                <a16:creationId xmlns:a16="http://schemas.microsoft.com/office/drawing/2014/main" id="{36DDF3E9-551C-6285-D24F-4734BEC9F3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1749" y="4354024"/>
            <a:ext cx="7087666" cy="1998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05941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12D875-81B6-8AF8-2530-DF08424793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1E0826DF-98C7-1A1E-20ED-4A3A64E0707F}"/>
              </a:ext>
            </a:extLst>
          </p:cNvPr>
          <p:cNvSpPr txBox="1"/>
          <p:nvPr/>
        </p:nvSpPr>
        <p:spPr>
          <a:xfrm>
            <a:off x="438913" y="859536"/>
            <a:ext cx="4832802" cy="12435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  <a:spcAft>
                <a:spcPts val="600"/>
              </a:spcAft>
            </a:pPr>
            <a:r>
              <a:rPr lang="en-US" sz="3400" b="1">
                <a:latin typeface="+mj-lt"/>
                <a:ea typeface="+mj-ea"/>
                <a:cs typeface="+mj-cs"/>
              </a:rPr>
              <a:t>Appendix D – Reliable events (&lt;150 ms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D8A0038C-1EAF-DF66-F5B5-C30A446DCDA2}"/>
              </a:ext>
            </a:extLst>
          </p:cNvPr>
          <p:cNvSpPr txBox="1"/>
          <p:nvPr/>
        </p:nvSpPr>
        <p:spPr>
          <a:xfrm>
            <a:off x="182370" y="2512611"/>
            <a:ext cx="4761503" cy="374184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We also recomputed onset/offset timing errors using all onsets/offsets annotated by at least one scorer, without the 150 </a:t>
            </a:r>
            <a:r>
              <a:rPr lang="en-US" sz="1400" dirty="0" err="1"/>
              <a:t>ms</a:t>
            </a:r>
            <a:r>
              <a:rPr lang="en-US" sz="1400" dirty="0"/>
              <a:t> agreement constraint.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SD and RMSE increase due to intrinsically ambiguous cycles, whereas mean bias changes little and the ranking remains unchanged.</a:t>
            </a:r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1400" dirty="0"/>
          </a:p>
          <a:p>
            <a:pPr indent="-228600">
              <a:lnSpc>
                <a:spcPct val="9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US" sz="1400" dirty="0"/>
              <a:t>After I2BSNR-based correction, the additional RMSE increase when using all cycles is modest compared with the much larger rise in inter-scorer disagreement.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EA9C3BD2-FA1A-8E25-C393-636FFB459E95}"/>
              </a:ext>
            </a:extLst>
          </p:cNvPr>
          <p:cNvSpPr txBox="1"/>
          <p:nvPr/>
        </p:nvSpPr>
        <p:spPr>
          <a:xfrm>
            <a:off x="9544050" y="306896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95406994-C6FE-CF33-066D-FD85A52C07E9}"/>
              </a:ext>
            </a:extLst>
          </p:cNvPr>
          <p:cNvSpPr txBox="1"/>
          <p:nvPr/>
        </p:nvSpPr>
        <p:spPr>
          <a:xfrm>
            <a:off x="5271715" y="4006805"/>
            <a:ext cx="61214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iming metrics including all cycles</a:t>
            </a:r>
            <a:endParaRPr lang="es-ES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7278B14-F00E-9538-944A-7FC886195495}"/>
              </a:ext>
            </a:extLst>
          </p:cNvPr>
          <p:cNvSpPr txBox="1"/>
          <p:nvPr/>
        </p:nvSpPr>
        <p:spPr>
          <a:xfrm>
            <a:off x="5271715" y="1155929"/>
            <a:ext cx="6121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Timing metric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using only reliable events with the 150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greement criterion</a:t>
            </a:r>
            <a:r>
              <a:rPr lang="es-ES" dirty="0">
                <a:effectLst/>
              </a:rPr>
              <a:t>  (Table VI)</a:t>
            </a:r>
            <a:endParaRPr lang="es-ES" dirty="0"/>
          </a:p>
        </p:txBody>
      </p:sp>
      <p:pic>
        <p:nvPicPr>
          <p:cNvPr id="3" name="Imagen 2" descr="Tabla&#10;&#10;El contenido generado por IA puede ser incorrecto.">
            <a:extLst>
              <a:ext uri="{FF2B5EF4-FFF2-40B4-BE49-F238E27FC236}">
                <a16:creationId xmlns:a16="http://schemas.microsoft.com/office/drawing/2014/main" id="{88C446BA-7F68-1F76-9B6A-7122388437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2588" y="1969367"/>
            <a:ext cx="3073400" cy="1770380"/>
          </a:xfrm>
          <a:prstGeom prst="rect">
            <a:avLst/>
          </a:prstGeom>
        </p:spPr>
      </p:pic>
      <p:pic>
        <p:nvPicPr>
          <p:cNvPr id="5" name="Imagen 4" descr="Tabla&#10;&#10;El contenido generado por IA puede ser incorrecto.">
            <a:extLst>
              <a:ext uri="{FF2B5EF4-FFF2-40B4-BE49-F238E27FC236}">
                <a16:creationId xmlns:a16="http://schemas.microsoft.com/office/drawing/2014/main" id="{5F6A1DDE-92A1-A736-2F14-E34EF38203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9408" y="4627087"/>
            <a:ext cx="3116580" cy="1779905"/>
          </a:xfrm>
          <a:prstGeom prst="rect">
            <a:avLst/>
          </a:prstGeom>
        </p:spPr>
      </p:pic>
      <p:pic>
        <p:nvPicPr>
          <p:cNvPr id="10" name="Imagen 9" descr="Una captura de pantalla de un celular&#10;&#10;El contenido generado por IA puede ser incorrecto.">
            <a:extLst>
              <a:ext uri="{FF2B5EF4-FFF2-40B4-BE49-F238E27FC236}">
                <a16:creationId xmlns:a16="http://schemas.microsoft.com/office/drawing/2014/main" id="{C93C4D64-6A75-B5E1-D2C1-295B3C0C70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41940" y="1969367"/>
            <a:ext cx="3051175" cy="1704975"/>
          </a:xfrm>
          <a:prstGeom prst="rect">
            <a:avLst/>
          </a:prstGeom>
        </p:spPr>
      </p:pic>
      <p:pic>
        <p:nvPicPr>
          <p:cNvPr id="12" name="Imagen 11" descr="Tabla&#10;&#10;El contenido generado por IA puede ser incorrecto.">
            <a:extLst>
              <a:ext uri="{FF2B5EF4-FFF2-40B4-BE49-F238E27FC236}">
                <a16:creationId xmlns:a16="http://schemas.microsoft.com/office/drawing/2014/main" id="{1AF65065-CEAC-FD05-05E2-AC21A2D991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48277" y="4613117"/>
            <a:ext cx="3238500" cy="1793875"/>
          </a:xfrm>
          <a:prstGeom prst="rect">
            <a:avLst/>
          </a:prstGeom>
        </p:spPr>
      </p:pic>
      <p:sp>
        <p:nvSpPr>
          <p:cNvPr id="13" name="CuadroTexto 12">
            <a:extLst>
              <a:ext uri="{FF2B5EF4-FFF2-40B4-BE49-F238E27FC236}">
                <a16:creationId xmlns:a16="http://schemas.microsoft.com/office/drawing/2014/main" id="{51CA1688-74CC-099A-A800-67DDBEE5F632}"/>
              </a:ext>
            </a:extLst>
          </p:cNvPr>
          <p:cNvSpPr txBox="1"/>
          <p:nvPr/>
        </p:nvSpPr>
        <p:spPr>
          <a:xfrm>
            <a:off x="5879976" y="4283804"/>
            <a:ext cx="5256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>
                <a:solidFill>
                  <a:srgbClr val="FF0000"/>
                </a:solidFill>
              </a:rPr>
              <a:t>Onset</a:t>
            </a:r>
            <a:r>
              <a:rPr lang="es-ES" dirty="0">
                <a:solidFill>
                  <a:srgbClr val="FF0000"/>
                </a:solidFill>
              </a:rPr>
              <a:t>				Offset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45F8006B-0086-A479-7032-1556FFDCB6FE}"/>
              </a:ext>
            </a:extLst>
          </p:cNvPr>
          <p:cNvSpPr txBox="1"/>
          <p:nvPr/>
        </p:nvSpPr>
        <p:spPr>
          <a:xfrm>
            <a:off x="5879976" y="1636904"/>
            <a:ext cx="5256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>
                <a:solidFill>
                  <a:srgbClr val="FF0000"/>
                </a:solidFill>
              </a:rPr>
              <a:t>Onset</a:t>
            </a:r>
            <a:r>
              <a:rPr lang="es-ES" dirty="0">
                <a:solidFill>
                  <a:srgbClr val="FF0000"/>
                </a:solidFill>
              </a:rPr>
              <a:t>				Offset</a:t>
            </a:r>
          </a:p>
        </p:txBody>
      </p:sp>
    </p:spTree>
    <p:extLst>
      <p:ext uri="{BB962C8B-B14F-4D97-AF65-F5344CB8AC3E}">
        <p14:creationId xmlns:p14="http://schemas.microsoft.com/office/powerpoint/2010/main" val="14651441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A225FDF9-5245-834C-9082-3E3FEFD5120F}">
  <we:reference id="WA200005566" version="3.0.0.3" store="Omex" storeType="OMEX"/>
  <we:alternateReferences>
    <we:reference id="WA200005566" version="3.0.0.3" store="WA200005566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872</Words>
  <Application>Microsoft Macintosh PowerPoint</Application>
  <PresentationFormat>Panorámica</PresentationFormat>
  <Paragraphs>62</Paragraphs>
  <Slides>7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3" baseType="lpstr">
      <vt:lpstr>Aptos</vt:lpstr>
      <vt:lpstr>Aptos Display</vt:lpstr>
      <vt:lpstr>Arial</vt:lpstr>
      <vt:lpstr>Calibri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bel Torres Cebrián</dc:creator>
  <cp:lastModifiedBy>Abel Torres Cebrián</cp:lastModifiedBy>
  <cp:revision>1</cp:revision>
  <dcterms:created xsi:type="dcterms:W3CDTF">2026-01-21T16:24:50Z</dcterms:created>
  <dcterms:modified xsi:type="dcterms:W3CDTF">2026-01-21T17:11:41Z</dcterms:modified>
</cp:coreProperties>
</file>